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Override1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68" r:id="rId2"/>
    <p:sldId id="257" r:id="rId3"/>
    <p:sldId id="258" r:id="rId4"/>
    <p:sldId id="276" r:id="rId5"/>
    <p:sldId id="299" r:id="rId6"/>
    <p:sldId id="289" r:id="rId7"/>
    <p:sldId id="298" r:id="rId8"/>
    <p:sldId id="300" r:id="rId9"/>
    <p:sldId id="256" r:id="rId10"/>
    <p:sldId id="260" r:id="rId11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820" userDrawn="1">
          <p15:clr>
            <a:srgbClr val="A4A3A4"/>
          </p15:clr>
        </p15:guide>
        <p15:guide id="2" pos="322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08" d="100"/>
          <a:sy n="108" d="100"/>
        </p:scale>
        <p:origin x="576" y="102"/>
      </p:cViewPr>
      <p:guideLst>
        <p:guide orient="horz" pos="1820"/>
        <p:guide pos="3228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BC120A0E-6525-487C-9EB8-4373E38113E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95EE1EB3-7705-4D7B-AF71-AA915A0ADA2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2782B0F1-12EC-4CFA-924A-F9F227A0F9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F0EAA-D360-4593-8CEE-2A1661DF0291}" type="datetimeFigureOut">
              <a:rPr lang="ko-KR" altLang="en-US" smtClean="0"/>
              <a:t>2026-06-30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055BC35C-232E-48F4-9402-9F2EB63863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663B189F-511A-4680-B9A9-CBA771DCCF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1D08B4-3D9F-455D-B0AB-24954CD565A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051491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A21B327B-42C5-48E3-B4BC-911AE0BEDB2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7ACA7761-3261-433C-B5A6-8B2A73041B4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FA139FD8-5BB5-45DE-BE7C-A4B1833EF3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F0EAA-D360-4593-8CEE-2A1661DF0291}" type="datetimeFigureOut">
              <a:rPr lang="ko-KR" altLang="en-US" smtClean="0"/>
              <a:t>2026-06-30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E3391593-9208-4375-BB67-6E50EB98F0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6F138A7C-5AA2-4BEF-BB39-F9199507E7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1D08B4-3D9F-455D-B0AB-24954CD565A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116891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C24EFC1A-8F41-4F89-A8F4-D09FC8DF5F3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535DB3EC-C386-4456-A253-780D6839599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B1415DAC-06E7-4644-B5C6-97A6CA207D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F0EAA-D360-4593-8CEE-2A1661DF0291}" type="datetimeFigureOut">
              <a:rPr lang="ko-KR" altLang="en-US" smtClean="0"/>
              <a:t>2026-06-30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9B331D9C-0D3A-44A8-8D21-CD5DEF495B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C772BDA6-64F0-4F98-99F1-FB4E1EF85C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1D08B4-3D9F-455D-B0AB-24954CD565A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040473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0EFF2E54-D0D4-45AB-8A39-ADDF20E7709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848A2C02-1F25-40E9-8117-DDA37CA3E4D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2F937A7F-73CC-49D6-8E1F-6F2AA301A0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F0EAA-D360-4593-8CEE-2A1661DF0291}" type="datetimeFigureOut">
              <a:rPr lang="ko-KR" altLang="en-US" smtClean="0"/>
              <a:t>2026-06-30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9BDBB5B7-2883-48FF-B19F-484245A8E1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256103F3-235A-424C-B103-44A720AC25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1D08B4-3D9F-455D-B0AB-24954CD565A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108134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DA205CE0-2D77-4356-B797-202F04F23A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4B66BDD8-103D-4709-9E6E-BF90468A549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D5C231F4-7DE6-4B05-8355-69A1E47BE6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F0EAA-D360-4593-8CEE-2A1661DF0291}" type="datetimeFigureOut">
              <a:rPr lang="ko-KR" altLang="en-US" smtClean="0"/>
              <a:t>2026-06-30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EEAF8D82-ACD0-4339-BBD2-B0E0AD6015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CA0EABDB-85EA-493B-8A17-FCBF2136FD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1D08B4-3D9F-455D-B0AB-24954CD565A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458517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2F7B7CEB-B3E8-4E74-A805-643FC030B82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FC09D5F4-9CB3-4A57-A6FB-74CC3521155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1E7DC4C5-10EC-46FB-B9AD-2EEE39BED69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5DF936E8-8B1C-4F9D-B9BE-12190C5EF7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F0EAA-D360-4593-8CEE-2A1661DF0291}" type="datetimeFigureOut">
              <a:rPr lang="ko-KR" altLang="en-US" smtClean="0"/>
              <a:t>2026-06-30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9CF116C1-7076-4565-B266-039411BDB2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866F91EE-CA68-4E4A-AC3B-01B045E372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1D08B4-3D9F-455D-B0AB-24954CD565A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756762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5D16EBD2-7DF0-4639-97C7-6A11A1A1284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F46987D3-1CE4-4AFA-8F87-379469213E4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2B34A496-A398-48EF-9C59-0703AE79A8C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D5A58C19-B40C-4E1A-8B7C-4A0A1A0DC13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B007BFBC-76CE-4454-AA5E-D9237A34811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929D8CD0-EC2B-4E16-9B92-2D58B2EF02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F0EAA-D360-4593-8CEE-2A1661DF0291}" type="datetimeFigureOut">
              <a:rPr lang="ko-KR" altLang="en-US" smtClean="0"/>
              <a:t>2026-06-30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FD9662B9-F38C-4C7D-AE31-633942400C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C9D5A0E3-43BC-4734-8272-3D6D36E06A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1D08B4-3D9F-455D-B0AB-24954CD565A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066220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62CCCA94-2E8A-43BF-AF53-B68F9F4CB57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A8235FE9-A6D8-47CB-94BB-B5F5D213F0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F0EAA-D360-4593-8CEE-2A1661DF0291}" type="datetimeFigureOut">
              <a:rPr lang="ko-KR" altLang="en-US" smtClean="0"/>
              <a:t>2026-06-30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8F4F988B-A7DA-46B7-9F09-0931165EC2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955F08BF-D652-4594-834E-987A94DF15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1D08B4-3D9F-455D-B0AB-24954CD565A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386175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66323142-C589-46F8-9D93-A32C1D2D67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F0EAA-D360-4593-8CEE-2A1661DF0291}" type="datetimeFigureOut">
              <a:rPr lang="ko-KR" altLang="en-US" smtClean="0"/>
              <a:t>2026-06-30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A2E17D50-D768-497E-862F-06BB009E13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7FBE1280-A514-49DE-B4BE-B8889A9E41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1D08B4-3D9F-455D-B0AB-24954CD565A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025979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086CB964-B005-4D17-9D04-A42325DCE8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665A6F1A-5AC0-411D-9637-14D5998642F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78CFBA8F-4839-40CF-9F06-E86CCA72518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240DD09D-8903-4068-B700-A3BBEF383E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F0EAA-D360-4593-8CEE-2A1661DF0291}" type="datetimeFigureOut">
              <a:rPr lang="ko-KR" altLang="en-US" smtClean="0"/>
              <a:t>2026-06-30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BDF07CD0-44BC-4755-8D1F-B81B86F1ED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04EAAF20-15DE-4319-8EC7-2CECF4AD65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1D08B4-3D9F-455D-B0AB-24954CD565A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179993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C7723465-AD85-4297-B591-3FCE3A7188C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509B7BFD-C0A1-4742-ABEA-D0DA05D5F43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FB5F8B02-0E8E-4FD5-93F3-CF652630373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9C0559CD-5894-491C-8CC7-95AEDD9FA6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F0EAA-D360-4593-8CEE-2A1661DF0291}" type="datetimeFigureOut">
              <a:rPr lang="ko-KR" altLang="en-US" smtClean="0"/>
              <a:t>2026-06-30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D60FDA07-950E-4993-AB80-1859688306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C318754E-353B-4838-8208-3CDA4E6EE8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1D08B4-3D9F-455D-B0AB-24954CD565A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214027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5B57CB11-2156-4710-81E7-725AABFE04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8F2430F9-B6A3-4064-AC71-A0C5B8799F2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318A2F4B-89B9-4E81-B1B7-2EDD635A459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DF0EAA-D360-4593-8CEE-2A1661DF0291}" type="datetimeFigureOut">
              <a:rPr lang="ko-KR" altLang="en-US" smtClean="0"/>
              <a:t>2026-06-30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D26B49BA-4C47-458E-9470-980B6E0DEDE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60940E9C-5E7E-4E63-8CF8-B5C034A576C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1D08B4-3D9F-455D-B0AB-24954CD565A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564692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slideLayout" Target="../slideLayouts/slideLayout2.xml"/><Relationship Id="rId1" Type="http://schemas.openxmlformats.org/officeDocument/2006/relationships/themeOverride" Target="../theme/themeOverride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0.png"/><Relationship Id="rId5" Type="http://schemas.openxmlformats.org/officeDocument/2006/relationships/image" Target="../media/image9.png"/><Relationship Id="rId4" Type="http://schemas.openxmlformats.org/officeDocument/2006/relationships/image" Target="../media/image8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4.bin"/><Relationship Id="rId3" Type="http://schemas.openxmlformats.org/officeDocument/2006/relationships/image" Target="../media/image11.emf"/><Relationship Id="rId7" Type="http://schemas.openxmlformats.org/officeDocument/2006/relationships/image" Target="../media/image13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1.xml"/><Relationship Id="rId6" Type="http://schemas.openxmlformats.org/officeDocument/2006/relationships/oleObject" Target="../embeddings/oleObject3.bin"/><Relationship Id="rId5" Type="http://schemas.openxmlformats.org/officeDocument/2006/relationships/image" Target="../media/image12.emf"/><Relationship Id="rId4" Type="http://schemas.openxmlformats.org/officeDocument/2006/relationships/oleObject" Target="../embeddings/oleObject2.bin"/><Relationship Id="rId9" Type="http://schemas.openxmlformats.org/officeDocument/2006/relationships/image" Target="../media/image14.em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emf"/><Relationship Id="rId2" Type="http://schemas.openxmlformats.org/officeDocument/2006/relationships/oleObject" Target="../embeddings/oleObject5.bin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16.emf"/><Relationship Id="rId4" Type="http://schemas.openxmlformats.org/officeDocument/2006/relationships/oleObject" Target="../embeddings/oleObject6.bin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emf"/><Relationship Id="rId7" Type="http://schemas.openxmlformats.org/officeDocument/2006/relationships/image" Target="../media/image19.emf"/><Relationship Id="rId2" Type="http://schemas.openxmlformats.org/officeDocument/2006/relationships/oleObject" Target="../embeddings/oleObject7.bin"/><Relationship Id="rId1" Type="http://schemas.openxmlformats.org/officeDocument/2006/relationships/slideLayout" Target="../slideLayouts/slideLayout1.xml"/><Relationship Id="rId6" Type="http://schemas.openxmlformats.org/officeDocument/2006/relationships/oleObject" Target="../embeddings/oleObject9.bin"/><Relationship Id="rId5" Type="http://schemas.openxmlformats.org/officeDocument/2006/relationships/image" Target="../media/image18.emf"/><Relationship Id="rId4" Type="http://schemas.openxmlformats.org/officeDocument/2006/relationships/oleObject" Target="../embeddings/oleObject8.bin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33AF8FFC-9580-7758-B101-2FB22F916F6D}"/>
              </a:ext>
            </a:extLst>
          </p:cNvPr>
          <p:cNvSpPr txBox="1"/>
          <p:nvPr/>
        </p:nvSpPr>
        <p:spPr>
          <a:xfrm>
            <a:off x="353687" y="336431"/>
            <a:ext cx="114155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1. 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직사각형 5">
            <a:extLst>
              <a:ext uri="{FF2B5EF4-FFF2-40B4-BE49-F238E27FC236}">
                <a16:creationId xmlns:a16="http://schemas.microsoft.com/office/drawing/2014/main" id="{F65CE50E-B8B8-8619-B8D6-489CAAA2E0BD}"/>
              </a:ext>
            </a:extLst>
          </p:cNvPr>
          <p:cNvSpPr/>
          <p:nvPr/>
        </p:nvSpPr>
        <p:spPr>
          <a:xfrm>
            <a:off x="1630518" y="4200543"/>
            <a:ext cx="6285535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1. Upregulated and downregulated genes in the transcriptome analysis of the lung samples. Significant cut-off criteria were |fold change| ≥ 2 and </a:t>
            </a:r>
            <a:r>
              <a:rPr lang="en-US" altLang="ko-KR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 0.05, compared CTL group, as determined with independent </a:t>
            </a:r>
            <a:r>
              <a:rPr lang="en-US" altLang="ko-KR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tests. </a:t>
            </a:r>
            <a:r>
              <a:rPr lang="en-GB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TL: PM</a:t>
            </a:r>
            <a:r>
              <a:rPr lang="en-GB" altLang="ko-KR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GB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-sensitized control mice; H: total cell number 1 X 10</a:t>
            </a:r>
            <a:r>
              <a:rPr lang="en-GB" altLang="ko-KR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GB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/day heat-killed of </a:t>
            </a:r>
            <a:r>
              <a:rPr lang="en-GB" altLang="ko-KR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. </a:t>
            </a:r>
            <a:r>
              <a:rPr lang="en-GB" altLang="ko-KR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aracasei</a:t>
            </a:r>
            <a:r>
              <a:rPr lang="en-GB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TG-E1-treated PM</a:t>
            </a:r>
            <a:r>
              <a:rPr lang="en-GB" altLang="ko-KR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GB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-sensitized mice. 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8" name="그룹 7">
            <a:extLst>
              <a:ext uri="{FF2B5EF4-FFF2-40B4-BE49-F238E27FC236}">
                <a16:creationId xmlns:a16="http://schemas.microsoft.com/office/drawing/2014/main" id="{8FFF29BE-334A-468B-B41E-3A47AD839341}"/>
              </a:ext>
            </a:extLst>
          </p:cNvPr>
          <p:cNvGrpSpPr/>
          <p:nvPr/>
        </p:nvGrpSpPr>
        <p:grpSpPr>
          <a:xfrm>
            <a:off x="1570008" y="1233577"/>
            <a:ext cx="8065698" cy="2484408"/>
            <a:chOff x="1570008" y="1233577"/>
            <a:chExt cx="8065698" cy="2484408"/>
          </a:xfrm>
        </p:grpSpPr>
        <p:grpSp>
          <p:nvGrpSpPr>
            <p:cNvPr id="5" name="그룹 4">
              <a:extLst>
                <a:ext uri="{FF2B5EF4-FFF2-40B4-BE49-F238E27FC236}">
                  <a16:creationId xmlns:a16="http://schemas.microsoft.com/office/drawing/2014/main" id="{DB34D226-188A-4C75-BC50-E3847EF26E7E}"/>
                </a:ext>
              </a:extLst>
            </p:cNvPr>
            <p:cNvGrpSpPr/>
            <p:nvPr/>
          </p:nvGrpSpPr>
          <p:grpSpPr>
            <a:xfrm>
              <a:off x="1630518" y="1293962"/>
              <a:ext cx="7815407" cy="2363638"/>
              <a:chOff x="1630518" y="1293962"/>
              <a:chExt cx="7815407" cy="2363638"/>
            </a:xfrm>
          </p:grpSpPr>
          <p:pic>
            <p:nvPicPr>
              <p:cNvPr id="10" name="그림 9">
                <a:extLst>
                  <a:ext uri="{FF2B5EF4-FFF2-40B4-BE49-F238E27FC236}">
                    <a16:creationId xmlns:a16="http://schemas.microsoft.com/office/drawing/2014/main" id="{33567A29-0ED1-B1BD-AEA5-D787598D3CA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10343" t="3216" r="1391" b="3811"/>
              <a:stretch/>
            </p:blipFill>
            <p:spPr>
              <a:xfrm>
                <a:off x="3838755" y="1293962"/>
                <a:ext cx="5607170" cy="2363638"/>
              </a:xfrm>
              <a:prstGeom prst="rect">
                <a:avLst/>
              </a:prstGeom>
            </p:spPr>
          </p:pic>
          <p:sp>
            <p:nvSpPr>
              <p:cNvPr id="3" name="직사각형 2">
                <a:extLst>
                  <a:ext uri="{FF2B5EF4-FFF2-40B4-BE49-F238E27FC236}">
                    <a16:creationId xmlns:a16="http://schemas.microsoft.com/office/drawing/2014/main" id="{69C52120-D4A3-43AC-B81B-8FFC77AA9141}"/>
                  </a:ext>
                </a:extLst>
              </p:cNvPr>
              <p:cNvSpPr/>
              <p:nvPr/>
            </p:nvSpPr>
            <p:spPr>
              <a:xfrm>
                <a:off x="1630518" y="2192019"/>
                <a:ext cx="2178289" cy="292388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>
                <a:spAutoFit/>
              </a:bodyPr>
              <a:lstStyle/>
              <a:p>
                <a:r>
                  <a:rPr lang="en-US" altLang="ko-KR" sz="1300" dirty="0">
                    <a:solidFill>
                      <a:schemeClr val="bg1">
                        <a:lumMod val="50000"/>
                      </a:schemeClr>
                    </a:solidFill>
                    <a:latin typeface="+mn-ea"/>
                    <a:cs typeface="Times New Roman" panose="02020603050405020304" pitchFamily="18" charset="0"/>
                  </a:rPr>
                  <a:t>h</a:t>
                </a:r>
                <a:r>
                  <a:rPr lang="en-GB" altLang="ko-KR" sz="1300" dirty="0">
                    <a:solidFill>
                      <a:schemeClr val="bg1">
                        <a:lumMod val="50000"/>
                      </a:schemeClr>
                    </a:solidFill>
                    <a:latin typeface="+mn-ea"/>
                    <a:cs typeface="Times New Roman" panose="02020603050405020304" pitchFamily="18" charset="0"/>
                  </a:rPr>
                  <a:t>eat-Killed ATG-E1-H</a:t>
                </a:r>
                <a:r>
                  <a:rPr lang="en-US" altLang="ko-KR" sz="1300" dirty="0">
                    <a:solidFill>
                      <a:schemeClr val="bg1">
                        <a:lumMod val="50000"/>
                      </a:schemeClr>
                    </a:solidFill>
                    <a:latin typeface="+mn-ea"/>
                    <a:cs typeface="Times New Roman" panose="02020603050405020304" pitchFamily="18" charset="0"/>
                  </a:rPr>
                  <a:t>/CTL </a:t>
                </a:r>
                <a:endParaRPr lang="ko-KR" altLang="en-US" sz="1300" dirty="0">
                  <a:solidFill>
                    <a:schemeClr val="bg1">
                      <a:lumMod val="50000"/>
                    </a:schemeClr>
                  </a:solidFill>
                  <a:latin typeface="+mn-ea"/>
                </a:endParaRPr>
              </a:p>
            </p:txBody>
          </p:sp>
        </p:grpSp>
        <p:sp>
          <p:nvSpPr>
            <p:cNvPr id="7" name="직사각형 6">
              <a:extLst>
                <a:ext uri="{FF2B5EF4-FFF2-40B4-BE49-F238E27FC236}">
                  <a16:creationId xmlns:a16="http://schemas.microsoft.com/office/drawing/2014/main" id="{7E765267-B1EC-4CBF-B875-A36CC9C5586D}"/>
                </a:ext>
              </a:extLst>
            </p:cNvPr>
            <p:cNvSpPr/>
            <p:nvPr/>
          </p:nvSpPr>
          <p:spPr>
            <a:xfrm>
              <a:off x="1570008" y="1233577"/>
              <a:ext cx="8065698" cy="2484408"/>
            </a:xfrm>
            <a:prstGeom prst="rect">
              <a:avLst/>
            </a:prstGeom>
            <a:noFill/>
            <a:ln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</p:grpSp>
    </p:spTree>
    <p:extLst>
      <p:ext uri="{BB962C8B-B14F-4D97-AF65-F5344CB8AC3E}">
        <p14:creationId xmlns:p14="http://schemas.microsoft.com/office/powerpoint/2010/main" val="3697592433"/>
      </p:ext>
    </p:extLst>
  </p:cSld>
  <p:clrMapOvr>
    <a:overrideClrMapping bg1="lt1" tx1="dk1" bg2="lt2" tx2="dk2" accent1="accent1" accent2="accent2" accent3="accent3" accent4="accent4" accent5="accent5" accent6="accent6" hlink="hlink" folHlink="folHlink"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CAD546EA-5EDF-46EA-BAFA-CE172F247DF0}"/>
              </a:ext>
            </a:extLst>
          </p:cNvPr>
          <p:cNvSpPr txBox="1"/>
          <p:nvPr/>
        </p:nvSpPr>
        <p:spPr>
          <a:xfrm>
            <a:off x="526215" y="327803"/>
            <a:ext cx="33290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S1. Sequences of the primers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3" name="표 2">
            <a:extLst>
              <a:ext uri="{FF2B5EF4-FFF2-40B4-BE49-F238E27FC236}">
                <a16:creationId xmlns:a16="http://schemas.microsoft.com/office/drawing/2014/main" id="{19EDE912-48EC-4A1F-B2C1-C5AD27A84736}"/>
              </a:ext>
            </a:extLst>
          </p:cNvPr>
          <p:cNvGraphicFramePr>
            <a:graphicFrameLocks noGrp="1"/>
          </p:cNvGraphicFramePr>
          <p:nvPr/>
        </p:nvGraphicFramePr>
        <p:xfrm>
          <a:off x="838651" y="1074567"/>
          <a:ext cx="10514698" cy="4225296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949592">
                  <a:extLst>
                    <a:ext uri="{9D8B030D-6E8A-4147-A177-3AD203B41FA5}">
                      <a16:colId xmlns:a16="http://schemas.microsoft.com/office/drawing/2014/main" val="1453152402"/>
                    </a:ext>
                  </a:extLst>
                </a:gridCol>
                <a:gridCol w="4499810">
                  <a:extLst>
                    <a:ext uri="{9D8B030D-6E8A-4147-A177-3AD203B41FA5}">
                      <a16:colId xmlns:a16="http://schemas.microsoft.com/office/drawing/2014/main" val="436567620"/>
                    </a:ext>
                  </a:extLst>
                </a:gridCol>
                <a:gridCol w="1191128">
                  <a:extLst>
                    <a:ext uri="{9D8B030D-6E8A-4147-A177-3AD203B41FA5}">
                      <a16:colId xmlns:a16="http://schemas.microsoft.com/office/drawing/2014/main" val="1753317091"/>
                    </a:ext>
                  </a:extLst>
                </a:gridCol>
                <a:gridCol w="3874168">
                  <a:extLst>
                    <a:ext uri="{9D8B030D-6E8A-4147-A177-3AD203B41FA5}">
                      <a16:colId xmlns:a16="http://schemas.microsoft.com/office/drawing/2014/main" val="3490164994"/>
                    </a:ext>
                  </a:extLst>
                </a:gridCol>
              </a:tblGrid>
              <a:tr h="366147">
                <a:tc>
                  <a:txBody>
                    <a:bodyPr/>
                    <a:lstStyle/>
                    <a:p>
                      <a:pPr algn="ctr" fontAlgn="base" latinLnBrk="1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b="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</a:t>
                      </a:r>
                      <a:endParaRPr lang="ko-KR" sz="12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770" marR="64770" marT="17780" marB="17780" anchor="ctr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1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b="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quence (5</a:t>
                      </a:r>
                      <a:r>
                        <a:rPr lang="ko-KR" altLang="ko-KR" sz="1200" b="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’</a:t>
                      </a:r>
                      <a:r>
                        <a:rPr lang="en-US" altLang="ko-KR" sz="1200" b="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</a:t>
                      </a:r>
                      <a:r>
                        <a:rPr lang="ko-KR" altLang="ko-KR" sz="1200" b="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’</a:t>
                      </a:r>
                      <a:r>
                        <a:rPr lang="en-US" altLang="ko-KR" sz="1200" b="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lang="ko-KR" altLang="ko-KR" sz="12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4770" marR="64770" marT="17780" marB="177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ase" latinLnBrk="1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b="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</a:t>
                      </a:r>
                      <a:endParaRPr lang="ko-KR" sz="12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770" marR="64770" marT="17780" marB="177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1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b="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quence (5</a:t>
                      </a:r>
                      <a:r>
                        <a:rPr lang="ko-KR" altLang="ko-KR" sz="1200" b="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’</a:t>
                      </a:r>
                      <a:r>
                        <a:rPr lang="en-US" altLang="ko-KR" sz="1200" b="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</a:t>
                      </a:r>
                      <a:r>
                        <a:rPr lang="ko-KR" altLang="ko-KR" sz="1200" b="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’</a:t>
                      </a:r>
                      <a:r>
                        <a:rPr lang="en-US" altLang="ko-KR" sz="1200" b="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lang="ko-KR" altLang="ko-KR" sz="12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4770" marR="64770" marT="17780" marB="177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77248546"/>
                  </a:ext>
                </a:extLst>
              </a:tr>
              <a:tr h="275654">
                <a:tc>
                  <a:txBody>
                    <a:bodyPr/>
                    <a:lstStyle/>
                    <a:p>
                      <a:pPr marL="97790" algn="l" fontAlgn="base" latinLnBrk="1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b="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XCL1</a:t>
                      </a:r>
                      <a:endParaRPr lang="ko-KR" sz="12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770" marR="64770" marT="17780" marB="177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110490" algn="l" fontAlgn="base" latinLnBrk="1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b="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Forward : CCGAAGTCATAGCCACAC</a:t>
                      </a:r>
                      <a:endParaRPr lang="ko-KR" sz="12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marL="110490" algn="l" fontAlgn="base" latinLnBrk="1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b="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Reverse : GTGCCATCAGAGCAGTCT</a:t>
                      </a:r>
                      <a:endParaRPr lang="ko-KR" sz="12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4770" marR="64770" marT="17780" marB="177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97790" algn="l" fontAlgn="base" latinLnBrk="1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iNOS-2</a:t>
                      </a:r>
                      <a:endParaRPr lang="ko-KR" sz="12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770" marR="64770" marT="17780" marB="177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110490" algn="l" fontAlgn="base" latinLnBrk="1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b="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ward : CGAAACGCTTCACTTCCAA</a:t>
                      </a:r>
                      <a:endParaRPr lang="ko-KR" altLang="ko-KR" sz="12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110490" algn="l" fontAlgn="base" latinLnBrk="1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b="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erse : TGAGCCTATATTGCTGTGGCT</a:t>
                      </a:r>
                      <a:endParaRPr lang="ko-KR" sz="12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770" marR="64770" marT="17780" marB="17780" anchor="ctr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45580433"/>
                  </a:ext>
                </a:extLst>
              </a:tr>
              <a:tr h="275654">
                <a:tc>
                  <a:txBody>
                    <a:bodyPr/>
                    <a:lstStyle/>
                    <a:p>
                      <a:pPr marL="97790" algn="l" fontAlgn="base" latinLnBrk="1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b="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IP2</a:t>
                      </a:r>
                      <a:endParaRPr lang="ko-KR" sz="12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770" marR="64770" marT="17780" marB="177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110490" algn="l" fontAlgn="base" latinLnBrk="1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b="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Forward : </a:t>
                      </a:r>
                      <a:r>
                        <a:rPr lang="en-US" altLang="ko-KR" sz="1200" b="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TGCCTGAAGACCCTGCCAAG</a:t>
                      </a:r>
                      <a:endParaRPr lang="ko-KR" sz="12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marL="110490" algn="l" fontAlgn="base" latinLnBrk="1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b="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Reverse : </a:t>
                      </a:r>
                      <a:r>
                        <a:rPr lang="en-US" altLang="ko-KR" sz="1200" b="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GGTCAGTTAGCCTTGCCTTTG</a:t>
                      </a:r>
                      <a:endParaRPr lang="ko-KR" sz="12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4770" marR="64770" marT="17780" marB="177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97790" algn="l" fontAlgn="base" latinLnBrk="1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COX-2</a:t>
                      </a:r>
                      <a:endParaRPr lang="ko-KR" sz="12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770" marR="64770" marT="17780" marB="177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110490" algn="l" fontAlgn="base" latinLnBrk="1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b="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ward : GGGTGTCCCTTCACTTCTTTCA</a:t>
                      </a:r>
                      <a:endParaRPr lang="ko-KR" altLang="ko-KR" sz="12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110490" algn="l" fontAlgn="base" latinLnBrk="1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b="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erse : TGGGAGGCACTTGCATTGA</a:t>
                      </a:r>
                      <a:endParaRPr lang="ko-KR" sz="12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770" marR="64770" marT="17780" marB="17780" anchor="ctr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97005551"/>
                  </a:ext>
                </a:extLst>
              </a:tr>
              <a:tr h="275178">
                <a:tc>
                  <a:txBody>
                    <a:bodyPr/>
                    <a:lstStyle/>
                    <a:p>
                      <a:pPr marL="97790" algn="l" fontAlgn="base" latinLnBrk="1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b="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TRAC</a:t>
                      </a:r>
                      <a:endParaRPr lang="ko-KR" sz="12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770" marR="64770" marT="17780" marB="177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110490" algn="l" fontAlgn="base" latinLnBrk="1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b="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Forward : CCCATGAAGACCTTCACCTC</a:t>
                      </a:r>
                      <a:endParaRPr lang="ko-KR" sz="12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marL="110490" algn="l" fontAlgn="base" latinLnBrk="1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b="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Reverse : ACTCTCGGCCTACATTGGTG</a:t>
                      </a:r>
                      <a:endParaRPr lang="ko-KR" sz="12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4770" marR="64770" marT="17780" marB="177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97790" algn="l" fontAlgn="base" latinLnBrk="1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b="0" kern="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ccludin</a:t>
                      </a:r>
                      <a:endParaRPr lang="ko-KR" sz="12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770" marR="64770" marT="17780" marB="177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110490" algn="l" fontAlgn="base" latinLnBrk="1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b="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ward : TGGCTATGGAGGCGGCTATGG</a:t>
                      </a:r>
                      <a:endParaRPr lang="ko-KR" sz="12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110490" algn="l" fontAlgn="base" latinLnBrk="1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b="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erse : AAGGAAGCGATGAAGCAGAAGGC</a:t>
                      </a:r>
                      <a:endParaRPr lang="ko-KR" sz="12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770" marR="64770" marT="17780" marB="17780" anchor="ctr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10888459"/>
                  </a:ext>
                </a:extLst>
              </a:tr>
              <a:tr h="275178">
                <a:tc>
                  <a:txBody>
                    <a:bodyPr/>
                    <a:lstStyle/>
                    <a:p>
                      <a:pPr marL="97790" algn="l" fontAlgn="base" latinLnBrk="1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b="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PV1</a:t>
                      </a:r>
                      <a:endParaRPr lang="ko-KR" sz="12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770" marR="64770" marT="17780" marB="177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110490" algn="l" fontAlgn="base" latinLnBrk="1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b="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Forward :CATCTTCACCACGGCTGCTTAC</a:t>
                      </a:r>
                      <a:endParaRPr lang="ko-KR" sz="12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marL="110490" algn="l" fontAlgn="base" latinLnBrk="1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b="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Reverse :CAGACAGGATCTCTCCAGTGAC</a:t>
                      </a:r>
                      <a:endParaRPr lang="ko-KR" sz="12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4770" marR="64770" marT="17780" marB="177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97790" algn="l" fontAlgn="base" latinLnBrk="1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Claduin-1</a:t>
                      </a:r>
                      <a:endParaRPr lang="ko-KR" sz="12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770" marR="64770" marT="17780" marB="177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110490" algn="l" fontAlgn="base" latinLnBrk="1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b="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ward : CTTGACCCCCATCAATGC</a:t>
                      </a:r>
                      <a:endParaRPr lang="ko-KR" altLang="ko-KR" sz="12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110490" algn="l" fontAlgn="base" latinLnBrk="1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b="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erse : CACCTCCCAGAAGGCAGA</a:t>
                      </a:r>
                      <a:endParaRPr lang="ko-KR" sz="12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770" marR="64770" marT="17780" marB="17780" anchor="ctr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83644055"/>
                  </a:ext>
                </a:extLst>
              </a:tr>
              <a:tr h="137827">
                <a:tc>
                  <a:txBody>
                    <a:bodyPr/>
                    <a:lstStyle/>
                    <a:p>
                      <a:pPr marL="97790" algn="l" fontAlgn="base" latinLnBrk="1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TRPA1</a:t>
                      </a:r>
                      <a:endParaRPr lang="ko-KR" sz="12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770" marR="64770" marT="17780" marB="177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110490" algn="l" fontAlgn="base" latinLnBrk="1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b="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Forward : TGAGATCGACCGGAGT</a:t>
                      </a:r>
                      <a:endParaRPr lang="ko-KR" sz="12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marL="110490" algn="l" fontAlgn="base" latinLnBrk="1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b="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Reverse :TGCTGAAGGCATCTTG</a:t>
                      </a:r>
                      <a:endParaRPr lang="ko-KR" sz="12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4770" marR="64770" marT="17780" marB="177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97790" algn="l" fontAlgn="base" latinLnBrk="1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Claduin-4</a:t>
                      </a:r>
                      <a:endParaRPr lang="ko-KR" sz="12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770" marR="64770" marT="17780" marB="177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110490" algn="l" fontAlgn="base" latinLnBrk="1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b="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ward : TGGGGACAGGCAAACCCCGGA</a:t>
                      </a:r>
                      <a:endParaRPr lang="ko-KR" altLang="ko-KR" sz="12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110490" algn="l" fontAlgn="base" latinLnBrk="1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b="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erse : CTTGCCGGCCGTAAGGAGCC</a:t>
                      </a:r>
                      <a:endParaRPr lang="ko-KR" sz="12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770" marR="64770" marT="17780" marB="17780" anchor="ctr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3741504"/>
                  </a:ext>
                </a:extLst>
              </a:tr>
              <a:tr h="413480">
                <a:tc>
                  <a:txBody>
                    <a:bodyPr/>
                    <a:lstStyle/>
                    <a:p>
                      <a:pPr marL="97790" algn="l" fontAlgn="base" latinLnBrk="1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b="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NF-</a:t>
                      </a:r>
                      <a:r>
                        <a:rPr lang="ko-KR" sz="1200" b="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α</a:t>
                      </a:r>
                      <a:endParaRPr lang="ko-KR" sz="12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770" marR="64770" marT="17780" marB="177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110490" algn="l" fontAlgn="base" latinLnBrk="1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b="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Forward : GGCTTTCCGAATTCACTGGAGCCT</a:t>
                      </a:r>
                      <a:endParaRPr lang="ko-KR" sz="12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marL="110490" algn="l" fontAlgn="base" latinLnBrk="1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b="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Reverse : CCCCGGCCTTCCAAATAAATACATTCATA</a:t>
                      </a:r>
                      <a:endParaRPr lang="ko-KR" sz="12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4770" marR="64770" marT="17780" marB="177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97790" algn="l" fontAlgn="base" latinLnBrk="1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Claduin-5</a:t>
                      </a:r>
                      <a:endParaRPr lang="ko-KR" sz="12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770" marR="64770" marT="17780" marB="177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110490" algn="l" fontAlgn="base" latinLnBrk="1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b="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ward : AGGCACGGGTAGCACTCACG</a:t>
                      </a:r>
                      <a:endParaRPr lang="ko-KR" altLang="ko-KR" sz="12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110490" algn="l" fontAlgn="base" latinLnBrk="1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b="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erse : CATAGTTCTTCTTGTCGTAAT</a:t>
                      </a:r>
                      <a:endParaRPr lang="ko-KR" sz="12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770" marR="64770" marT="17780" marB="17780" anchor="ctr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4780402"/>
                  </a:ext>
                </a:extLst>
              </a:tr>
              <a:tr h="137827">
                <a:tc>
                  <a:txBody>
                    <a:bodyPr/>
                    <a:lstStyle/>
                    <a:p>
                      <a:pPr marL="97790" algn="l" fontAlgn="base" latinLnBrk="1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b="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MUC5AC</a:t>
                      </a:r>
                      <a:endParaRPr lang="ko-KR" sz="12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770" marR="64770" marT="17780" marB="177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110490" algn="l" fontAlgn="base" latinLnBrk="1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b="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ward : AGAATATCTTTCAGGACCCCTGCT </a:t>
                      </a:r>
                      <a:endParaRPr lang="ko-KR" sz="12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110490" algn="l" fontAlgn="base" latinLnBrk="1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b="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erse : ACACCAGTGCTGAGCATACTTTT</a:t>
                      </a:r>
                      <a:endParaRPr lang="ko-KR" sz="12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770" marR="64770" marT="17780" marB="177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97790" algn="l" fontAlgn="base" latinLnBrk="1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b="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PDH</a:t>
                      </a:r>
                      <a:endParaRPr lang="ko-KR" sz="12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770" marR="64770" marT="17780" marB="177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110490" algn="l" fontAlgn="base" latinLnBrk="1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b="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ward : GTCTTCCTGGGCAAGCAGTA</a:t>
                      </a:r>
                      <a:endParaRPr lang="ko-KR" sz="12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110490" algn="l" fontAlgn="base" latinLnBrk="1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b="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erse : CTGGACAGAAACCCCACTTC</a:t>
                      </a:r>
                      <a:endParaRPr lang="ko-KR" sz="12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770" marR="64770" marT="17780" marB="17780" anchor="ctr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3739917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51557434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AE0AEA94-12F0-4319-85B2-2E65053EC882}"/>
              </a:ext>
            </a:extLst>
          </p:cNvPr>
          <p:cNvSpPr txBox="1"/>
          <p:nvPr/>
        </p:nvSpPr>
        <p:spPr>
          <a:xfrm>
            <a:off x="296614" y="102568"/>
            <a:ext cx="975315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2. </a:t>
            </a:r>
          </a:p>
          <a:p>
            <a:endParaRPr lang="en-US" altLang="ko-KR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ko-KR" sz="1200" dirty="0">
                <a:latin typeface="Times New Roman" panose="02020603050405020304" pitchFamily="18" charset="0"/>
                <a:ea typeface="나눔스퀘어_ac" panose="020B0600000101010101" pitchFamily="50" charset="-127"/>
                <a:cs typeface="Times New Roman" panose="02020603050405020304" pitchFamily="18" charset="0"/>
              </a:rPr>
              <a:t>(A)Toll-like receptor signaling pathway (mmu04620)</a:t>
            </a:r>
          </a:p>
        </p:txBody>
      </p:sp>
      <p:grpSp>
        <p:nvGrpSpPr>
          <p:cNvPr id="12" name="그룹 11">
            <a:extLst>
              <a:ext uri="{FF2B5EF4-FFF2-40B4-BE49-F238E27FC236}">
                <a16:creationId xmlns:a16="http://schemas.microsoft.com/office/drawing/2014/main" id="{850FFFC4-A5D3-49AF-99B0-12691DC3BFBB}"/>
              </a:ext>
            </a:extLst>
          </p:cNvPr>
          <p:cNvGrpSpPr/>
          <p:nvPr/>
        </p:nvGrpSpPr>
        <p:grpSpPr>
          <a:xfrm>
            <a:off x="1579306" y="748899"/>
            <a:ext cx="8556731" cy="4573599"/>
            <a:chOff x="1003768" y="760622"/>
            <a:chExt cx="9856216" cy="5665004"/>
          </a:xfrm>
        </p:grpSpPr>
        <p:pic>
          <p:nvPicPr>
            <p:cNvPr id="5" name="그림 4">
              <a:extLst>
                <a:ext uri="{FF2B5EF4-FFF2-40B4-BE49-F238E27FC236}">
                  <a16:creationId xmlns:a16="http://schemas.microsoft.com/office/drawing/2014/main" id="{42BF4103-D0EF-445E-843C-D01DD8847CC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03768" y="760622"/>
              <a:ext cx="9856216" cy="5665004"/>
            </a:xfrm>
            <a:prstGeom prst="rect">
              <a:avLst/>
            </a:prstGeom>
          </p:spPr>
        </p:pic>
        <p:pic>
          <p:nvPicPr>
            <p:cNvPr id="8" name="그림 7">
              <a:extLst>
                <a:ext uri="{FF2B5EF4-FFF2-40B4-BE49-F238E27FC236}">
                  <a16:creationId xmlns:a16="http://schemas.microsoft.com/office/drawing/2014/main" id="{EF54BAC1-AF04-4FA9-BCF5-8D08090F3976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077966" y="784068"/>
              <a:ext cx="1739431" cy="391336"/>
            </a:xfrm>
            <a:prstGeom prst="rect">
              <a:avLst/>
            </a:prstGeom>
          </p:spPr>
        </p:pic>
      </p:grpSp>
      <p:sp>
        <p:nvSpPr>
          <p:cNvPr id="2" name="직사각형 1">
            <a:extLst>
              <a:ext uri="{FF2B5EF4-FFF2-40B4-BE49-F238E27FC236}">
                <a16:creationId xmlns:a16="http://schemas.microsoft.com/office/drawing/2014/main" id="{E234DCB0-BDA6-424F-B9D1-B42FB4152B90}"/>
              </a:ext>
            </a:extLst>
          </p:cNvPr>
          <p:cNvSpPr/>
          <p:nvPr/>
        </p:nvSpPr>
        <p:spPr>
          <a:xfrm>
            <a:off x="1456070" y="5412059"/>
            <a:ext cx="8556731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800"/>
              </a:spcAft>
            </a:pPr>
            <a:r>
              <a:rPr lang="en-US" altLang="ko-KR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2. KEGG mapper of the transcriptome analysis in lung of heat-killed </a:t>
            </a:r>
            <a:r>
              <a:rPr lang="en-US" altLang="ko-KR" sz="12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. </a:t>
            </a:r>
            <a:r>
              <a:rPr lang="en-US" altLang="ko-KR" sz="1200" i="1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aracasei</a:t>
            </a:r>
            <a:r>
              <a:rPr lang="en-US" altLang="ko-KR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TG-E1_DH. The expression levels of the genes included in the core gene of the KEGG term are represented. Statistically significant genes are indicated in red and blue, while non-significant genes are indicated in yellow and green. (A) Toll-like receptor signaling pathway (mmu04620), (B) Neutrophil extracellular trap formation (mmu04613), and (C)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ytokine-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ytokine_receptor_interaction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mmu04060)</a:t>
            </a:r>
            <a:r>
              <a:rPr lang="en-US" altLang="ko-KR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endParaRPr lang="ko-KR" altLang="ko-KR" sz="1200" kern="100" dirty="0">
              <a:latin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3835119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AE0AEA94-12F0-4319-85B2-2E65053EC882}"/>
              </a:ext>
            </a:extLst>
          </p:cNvPr>
          <p:cNvSpPr txBox="1"/>
          <p:nvPr/>
        </p:nvSpPr>
        <p:spPr>
          <a:xfrm>
            <a:off x="432672" y="137436"/>
            <a:ext cx="972644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2 (continued). </a:t>
            </a:r>
          </a:p>
          <a:p>
            <a:endParaRPr lang="en-US" altLang="ko-KR" sz="1200" dirty="0">
              <a:latin typeface="Times New Roman" panose="02020603050405020304" pitchFamily="18" charset="0"/>
              <a:ea typeface="나눔스퀘어_ac" panose="020B0600000101010101" pitchFamily="50" charset="-127"/>
              <a:cs typeface="Times New Roman" panose="02020603050405020304" pitchFamily="18" charset="0"/>
            </a:endParaRPr>
          </a:p>
          <a:p>
            <a:r>
              <a:rPr lang="en-US" altLang="ko-KR" sz="1200" dirty="0">
                <a:latin typeface="Times New Roman" panose="02020603050405020304" pitchFamily="18" charset="0"/>
                <a:ea typeface="나눔스퀘어_ac" panose="020B0600000101010101" pitchFamily="50" charset="-127"/>
                <a:cs typeface="Times New Roman" panose="02020603050405020304" pitchFamily="18" charset="0"/>
              </a:rPr>
              <a:t>(B) Neutrophil extracellular trap formation (mmu04613)</a:t>
            </a:r>
          </a:p>
        </p:txBody>
      </p:sp>
      <p:grpSp>
        <p:nvGrpSpPr>
          <p:cNvPr id="4" name="그룹 3">
            <a:extLst>
              <a:ext uri="{FF2B5EF4-FFF2-40B4-BE49-F238E27FC236}">
                <a16:creationId xmlns:a16="http://schemas.microsoft.com/office/drawing/2014/main" id="{3D45DB2C-E27A-4487-B096-4A162394F740}"/>
              </a:ext>
            </a:extLst>
          </p:cNvPr>
          <p:cNvGrpSpPr/>
          <p:nvPr/>
        </p:nvGrpSpPr>
        <p:grpSpPr>
          <a:xfrm>
            <a:off x="1045234" y="896497"/>
            <a:ext cx="10101531" cy="5746429"/>
            <a:chOff x="1961462" y="667545"/>
            <a:chExt cx="7940828" cy="5872750"/>
          </a:xfrm>
        </p:grpSpPr>
        <p:pic>
          <p:nvPicPr>
            <p:cNvPr id="3" name="그림 2">
              <a:extLst>
                <a:ext uri="{FF2B5EF4-FFF2-40B4-BE49-F238E27FC236}">
                  <a16:creationId xmlns:a16="http://schemas.microsoft.com/office/drawing/2014/main" id="{AB0527C6-8964-4EE4-A979-77E88D9DA24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61462" y="667545"/>
              <a:ext cx="7940828" cy="5872750"/>
            </a:xfrm>
            <a:prstGeom prst="rect">
              <a:avLst/>
            </a:prstGeom>
          </p:spPr>
        </p:pic>
        <p:pic>
          <p:nvPicPr>
            <p:cNvPr id="8" name="그림 7">
              <a:extLst>
                <a:ext uri="{FF2B5EF4-FFF2-40B4-BE49-F238E27FC236}">
                  <a16:creationId xmlns:a16="http://schemas.microsoft.com/office/drawing/2014/main" id="{EF54BAC1-AF04-4FA9-BCF5-8D08090F3976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162859" y="667545"/>
              <a:ext cx="1739431" cy="391336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9857045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C7395D31-92B0-4AF8-9652-B9F7FAAE23AA}"/>
              </a:ext>
            </a:extLst>
          </p:cNvPr>
          <p:cNvSpPr txBox="1"/>
          <p:nvPr/>
        </p:nvSpPr>
        <p:spPr>
          <a:xfrm>
            <a:off x="297302" y="478676"/>
            <a:ext cx="38459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 Cytokine-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ytokine_receptor_interaction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mmu04060)</a:t>
            </a:r>
          </a:p>
        </p:txBody>
      </p:sp>
      <p:pic>
        <p:nvPicPr>
          <p:cNvPr id="5" name="그림 4">
            <a:extLst>
              <a:ext uri="{FF2B5EF4-FFF2-40B4-BE49-F238E27FC236}">
                <a16:creationId xmlns:a16="http://schemas.microsoft.com/office/drawing/2014/main" id="{6DC50282-4847-4AA4-A94D-8FF4B160580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79502" y="795151"/>
            <a:ext cx="7904470" cy="5094971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63D4777A-1548-418D-990B-B08273B04781}"/>
              </a:ext>
            </a:extLst>
          </p:cNvPr>
          <p:cNvSpPr txBox="1"/>
          <p:nvPr/>
        </p:nvSpPr>
        <p:spPr>
          <a:xfrm>
            <a:off x="297298" y="162201"/>
            <a:ext cx="86854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2 (continued).</a:t>
            </a:r>
          </a:p>
        </p:txBody>
      </p:sp>
    </p:spTree>
    <p:extLst>
      <p:ext uri="{BB962C8B-B14F-4D97-AF65-F5344CB8AC3E}">
        <p14:creationId xmlns:p14="http://schemas.microsoft.com/office/powerpoint/2010/main" val="108188232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>
            <a:extLst>
              <a:ext uri="{FF2B5EF4-FFF2-40B4-BE49-F238E27FC236}">
                <a16:creationId xmlns:a16="http://schemas.microsoft.com/office/drawing/2014/main" id="{2F949200-45F5-F44E-A988-15E6714F353A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35104" y="876287"/>
            <a:ext cx="3038753" cy="2025835"/>
          </a:xfrm>
          <a:prstGeom prst="rect">
            <a:avLst/>
          </a:prstGeom>
        </p:spPr>
      </p:pic>
      <p:pic>
        <p:nvPicPr>
          <p:cNvPr id="7" name="그림 6">
            <a:extLst>
              <a:ext uri="{FF2B5EF4-FFF2-40B4-BE49-F238E27FC236}">
                <a16:creationId xmlns:a16="http://schemas.microsoft.com/office/drawing/2014/main" id="{D8932CD7-AA09-C01B-E159-9AB705084C4B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61337" y="802788"/>
            <a:ext cx="2966476" cy="1977652"/>
          </a:xfrm>
          <a:prstGeom prst="rect">
            <a:avLst/>
          </a:prstGeom>
        </p:spPr>
      </p:pic>
      <p:pic>
        <p:nvPicPr>
          <p:cNvPr id="9" name="그림 8">
            <a:extLst>
              <a:ext uri="{FF2B5EF4-FFF2-40B4-BE49-F238E27FC236}">
                <a16:creationId xmlns:a16="http://schemas.microsoft.com/office/drawing/2014/main" id="{F47CF331-3C08-0826-4226-1DABB84FDC41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93768" y="958065"/>
            <a:ext cx="2920769" cy="1877637"/>
          </a:xfrm>
          <a:prstGeom prst="rect">
            <a:avLst/>
          </a:prstGeom>
        </p:spPr>
      </p:pic>
      <p:pic>
        <p:nvPicPr>
          <p:cNvPr id="12" name="그림 11">
            <a:extLst>
              <a:ext uri="{FF2B5EF4-FFF2-40B4-BE49-F238E27FC236}">
                <a16:creationId xmlns:a16="http://schemas.microsoft.com/office/drawing/2014/main" id="{4D4D82F8-E165-B6CC-A4AF-BBA44D8A24E1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9808" y="3291975"/>
            <a:ext cx="3520976" cy="2222615"/>
          </a:xfrm>
          <a:prstGeom prst="rect">
            <a:avLst/>
          </a:prstGeom>
        </p:spPr>
      </p:pic>
      <p:pic>
        <p:nvPicPr>
          <p:cNvPr id="13" name="그림 12">
            <a:extLst>
              <a:ext uri="{FF2B5EF4-FFF2-40B4-BE49-F238E27FC236}">
                <a16:creationId xmlns:a16="http://schemas.microsoft.com/office/drawing/2014/main" id="{959EC69B-47AA-535B-824F-4021EFD49A21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71689" y="3133760"/>
            <a:ext cx="4275348" cy="2380831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4B564492-7980-EA98-CE12-6598E1B2462B}"/>
              </a:ext>
            </a:extLst>
          </p:cNvPr>
          <p:cNvSpPr txBox="1"/>
          <p:nvPr/>
        </p:nvSpPr>
        <p:spPr>
          <a:xfrm>
            <a:off x="1030576" y="5729856"/>
            <a:ext cx="10130847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ko-KR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3</a:t>
            </a:r>
            <a:r>
              <a:rPr lang="ko-KR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ko-KR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lpha</a:t>
            </a:r>
            <a:r>
              <a:rPr lang="ko-KR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and </a:t>
            </a:r>
            <a:r>
              <a:rPr lang="ko-KR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eta-diversity</a:t>
            </a:r>
            <a:r>
              <a:rPr lang="ko-KR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alyses</a:t>
            </a:r>
            <a:r>
              <a:rPr lang="ko-KR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ko-KR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xploratory</a:t>
            </a:r>
            <a:r>
              <a:rPr lang="ko-KR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rrelations</a:t>
            </a:r>
            <a:r>
              <a:rPr lang="ko-KR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etween</a:t>
            </a:r>
            <a:r>
              <a:rPr lang="ko-KR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ut</a:t>
            </a:r>
            <a:r>
              <a:rPr lang="ko-KR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icrobiota</a:t>
            </a:r>
            <a:r>
              <a:rPr lang="ko-KR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ko-KR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irway</a:t>
            </a:r>
            <a:r>
              <a:rPr lang="ko-KR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flammatory</a:t>
            </a:r>
            <a:r>
              <a:rPr lang="ko-KR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rkers</a:t>
            </a:r>
            <a:r>
              <a:rPr lang="ko-KR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br>
              <a:rPr lang="ko-KR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ko-KR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ko-KR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ko-KR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ko-KR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hannon</a:t>
            </a:r>
            <a:r>
              <a:rPr lang="ko-KR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dex</a:t>
            </a:r>
            <a:r>
              <a:rPr lang="ko-KR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(</a:t>
            </a:r>
            <a:r>
              <a:rPr lang="ko-KR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ko-KR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Chao1 </a:t>
            </a:r>
            <a:r>
              <a:rPr lang="ko-KR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stimator</a:t>
            </a:r>
            <a:r>
              <a:rPr lang="ko-KR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ere</a:t>
            </a:r>
            <a:r>
              <a:rPr lang="ko-KR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sed</a:t>
            </a:r>
            <a:r>
              <a:rPr lang="ko-KR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o</a:t>
            </a:r>
            <a:r>
              <a:rPr lang="ko-KR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ssess</a:t>
            </a:r>
            <a:r>
              <a:rPr lang="ko-KR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lpha</a:t>
            </a:r>
            <a:r>
              <a:rPr lang="ko-KR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iversity</a:t>
            </a:r>
            <a:r>
              <a:rPr lang="ko-KR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(C) Principal </a:t>
            </a:r>
            <a:r>
              <a:rPr lang="ko-KR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ordinate</a:t>
            </a:r>
            <a:r>
              <a:rPr lang="ko-KR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alysis</a:t>
            </a:r>
            <a:r>
              <a:rPr lang="ko-KR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ased</a:t>
            </a:r>
            <a:r>
              <a:rPr lang="ko-KR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n</a:t>
            </a:r>
            <a:r>
              <a:rPr lang="ko-KR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ray</a:t>
            </a:r>
            <a:r>
              <a:rPr lang="ko-KR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–</a:t>
            </a:r>
            <a:r>
              <a:rPr lang="ko-KR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urtis</a:t>
            </a:r>
            <a:r>
              <a:rPr lang="ko-KR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issimilarity</a:t>
            </a:r>
            <a:r>
              <a:rPr lang="ko-KR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as</a:t>
            </a:r>
            <a:r>
              <a:rPr lang="ko-KR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sed</a:t>
            </a:r>
            <a:r>
              <a:rPr lang="ko-KR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o</a:t>
            </a:r>
            <a:r>
              <a:rPr lang="ko-KR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valuate</a:t>
            </a:r>
            <a:r>
              <a:rPr lang="ko-KR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eta</a:t>
            </a:r>
            <a:r>
              <a:rPr lang="ko-KR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iversity</a:t>
            </a:r>
            <a:r>
              <a:rPr lang="ko-KR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(</a:t>
            </a:r>
            <a:r>
              <a:rPr lang="ko-KR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ko-KR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ko-KR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pearman</a:t>
            </a:r>
            <a:r>
              <a:rPr lang="ko-KR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rrelation</a:t>
            </a:r>
            <a:r>
              <a:rPr lang="ko-KR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eatmap</a:t>
            </a:r>
            <a:r>
              <a:rPr lang="ko-KR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etween</a:t>
            </a:r>
            <a:r>
              <a:rPr lang="ko-KR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elected</a:t>
            </a:r>
            <a:r>
              <a:rPr lang="ko-KR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acterial</a:t>
            </a:r>
            <a:r>
              <a:rPr lang="ko-KR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axa</a:t>
            </a:r>
            <a:r>
              <a:rPr lang="ko-KR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BALF </a:t>
            </a:r>
            <a:r>
              <a:rPr lang="ko-KR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flammatory</a:t>
            </a:r>
            <a:r>
              <a:rPr lang="ko-KR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diators</a:t>
            </a:r>
            <a:r>
              <a:rPr lang="ko-KR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(</a:t>
            </a:r>
            <a:r>
              <a:rPr lang="ko-KR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r>
              <a:rPr lang="ko-KR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ko-KR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presentative</a:t>
            </a:r>
            <a:r>
              <a:rPr lang="ko-KR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catter</a:t>
            </a:r>
            <a:r>
              <a:rPr lang="ko-KR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lots</a:t>
            </a:r>
            <a:r>
              <a:rPr lang="ko-KR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howing</a:t>
            </a:r>
            <a:r>
              <a:rPr lang="ko-KR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verse</a:t>
            </a:r>
            <a:r>
              <a:rPr lang="ko-KR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rrelations</a:t>
            </a:r>
            <a:r>
              <a:rPr lang="ko-KR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etween</a:t>
            </a:r>
            <a:r>
              <a:rPr lang="ko-KR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elected</a:t>
            </a:r>
            <a:r>
              <a:rPr lang="ko-KR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axa</a:t>
            </a:r>
            <a:r>
              <a:rPr lang="ko-KR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BALF IL-1α </a:t>
            </a:r>
            <a:r>
              <a:rPr lang="ko-KR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evels</a:t>
            </a:r>
            <a:r>
              <a:rPr lang="ko-KR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ko-KR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rrelation</a:t>
            </a:r>
            <a:r>
              <a:rPr lang="ko-KR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alyses</a:t>
            </a:r>
            <a:r>
              <a:rPr lang="ko-KR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ere</a:t>
            </a:r>
            <a:r>
              <a:rPr lang="ko-KR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xploratory</a:t>
            </a:r>
            <a:r>
              <a:rPr lang="ko-KR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ko-KR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dicate</a:t>
            </a:r>
            <a:r>
              <a:rPr lang="ko-KR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ssociations</a:t>
            </a:r>
            <a:r>
              <a:rPr lang="ko-KR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ko-KR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ot</a:t>
            </a:r>
            <a:r>
              <a:rPr lang="ko-KR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ausality</a:t>
            </a:r>
            <a:r>
              <a:rPr lang="ko-KR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B2FDE7CD-7271-915F-346E-A3469D977FB7}"/>
              </a:ext>
            </a:extLst>
          </p:cNvPr>
          <p:cNvSpPr txBox="1"/>
          <p:nvPr/>
        </p:nvSpPr>
        <p:spPr>
          <a:xfrm>
            <a:off x="1001751" y="745727"/>
            <a:ext cx="3753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D7E05005-54D7-AF2C-C313-6DA9A6D205B9}"/>
              </a:ext>
            </a:extLst>
          </p:cNvPr>
          <p:cNvSpPr txBox="1"/>
          <p:nvPr/>
        </p:nvSpPr>
        <p:spPr>
          <a:xfrm>
            <a:off x="4888950" y="623936"/>
            <a:ext cx="3753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27E614F9-1571-8E9E-5D34-F9B3A6134143}"/>
              </a:ext>
            </a:extLst>
          </p:cNvPr>
          <p:cNvSpPr txBox="1"/>
          <p:nvPr/>
        </p:nvSpPr>
        <p:spPr>
          <a:xfrm>
            <a:off x="8111940" y="777814"/>
            <a:ext cx="4526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1F1C0010-9BF2-CF1E-6C2B-3E2FB0205F1C}"/>
              </a:ext>
            </a:extLst>
          </p:cNvPr>
          <p:cNvSpPr txBox="1"/>
          <p:nvPr/>
        </p:nvSpPr>
        <p:spPr>
          <a:xfrm>
            <a:off x="1013068" y="3014977"/>
            <a:ext cx="4445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)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3F93AA20-AA35-3AAD-DE85-F7510DE78C8B}"/>
              </a:ext>
            </a:extLst>
          </p:cNvPr>
          <p:cNvSpPr txBox="1"/>
          <p:nvPr/>
        </p:nvSpPr>
        <p:spPr>
          <a:xfrm>
            <a:off x="4938470" y="2995261"/>
            <a:ext cx="4962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E)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790B1361-FD52-A720-573E-C3F8F44C4745}"/>
              </a:ext>
            </a:extLst>
          </p:cNvPr>
          <p:cNvSpPr txBox="1"/>
          <p:nvPr/>
        </p:nvSpPr>
        <p:spPr>
          <a:xfrm>
            <a:off x="517123" y="161597"/>
            <a:ext cx="10797413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3</a:t>
            </a:r>
            <a:r>
              <a:rPr lang="ko-KR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842961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개체 3">
            <a:extLst>
              <a:ext uri="{FF2B5EF4-FFF2-40B4-BE49-F238E27FC236}">
                <a16:creationId xmlns:a16="http://schemas.microsoft.com/office/drawing/2014/main" id="{67A7E454-1F65-449F-ACE2-9FD2716529E7}"/>
              </a:ext>
            </a:extLst>
          </p:cNvPr>
          <p:cNvGraphicFramePr>
            <a:graphicFrameLocks noChangeAspect="1"/>
          </p:cNvGraphicFramePr>
          <p:nvPr/>
        </p:nvGraphicFramePr>
        <p:xfrm>
          <a:off x="2620963" y="708025"/>
          <a:ext cx="3025775" cy="21780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" imgW="4052247" imgH="2918328" progId="Prism8.Document">
                  <p:embed/>
                </p:oleObj>
              </mc:Choice>
              <mc:Fallback>
                <p:oleObj name="Prism 8" r:id="rId2" imgW="4052247" imgH="2918328" progId="Prism8.Document">
                  <p:embed/>
                  <p:pic>
                    <p:nvPicPr>
                      <p:cNvPr id="4" name="개체 3">
                        <a:extLst>
                          <a:ext uri="{FF2B5EF4-FFF2-40B4-BE49-F238E27FC236}">
                            <a16:creationId xmlns:a16="http://schemas.microsoft.com/office/drawing/2014/main" id="{67A7E454-1F65-449F-ACE2-9FD2716529E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620963" y="708025"/>
                        <a:ext cx="3025775" cy="21780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개체 7">
            <a:extLst>
              <a:ext uri="{FF2B5EF4-FFF2-40B4-BE49-F238E27FC236}">
                <a16:creationId xmlns:a16="http://schemas.microsoft.com/office/drawing/2014/main" id="{2B03F836-3ED4-4D13-9E2E-F1E0137E8733}"/>
              </a:ext>
            </a:extLst>
          </p:cNvPr>
          <p:cNvGraphicFramePr>
            <a:graphicFrameLocks noChangeAspect="1"/>
          </p:cNvGraphicFramePr>
          <p:nvPr/>
        </p:nvGraphicFramePr>
        <p:xfrm>
          <a:off x="5781675" y="706353"/>
          <a:ext cx="3022600" cy="21796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4" imgW="4079617" imgH="2945700" progId="Prism8.Document">
                  <p:embed/>
                </p:oleObj>
              </mc:Choice>
              <mc:Fallback>
                <p:oleObj name="Prism 8" r:id="rId4" imgW="4079617" imgH="2945700" progId="Prism8.Document">
                  <p:embed/>
                  <p:pic>
                    <p:nvPicPr>
                      <p:cNvPr id="8" name="개체 7">
                        <a:extLst>
                          <a:ext uri="{FF2B5EF4-FFF2-40B4-BE49-F238E27FC236}">
                            <a16:creationId xmlns:a16="http://schemas.microsoft.com/office/drawing/2014/main" id="{2B03F836-3ED4-4D13-9E2E-F1E0137E873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5781675" y="706353"/>
                        <a:ext cx="3022600" cy="21796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개체 8">
            <a:extLst>
              <a:ext uri="{FF2B5EF4-FFF2-40B4-BE49-F238E27FC236}">
                <a16:creationId xmlns:a16="http://schemas.microsoft.com/office/drawing/2014/main" id="{9EE7D44F-78B8-4C56-B4FF-CFA4527088F8}"/>
              </a:ext>
            </a:extLst>
          </p:cNvPr>
          <p:cNvGraphicFramePr>
            <a:graphicFrameLocks/>
          </p:cNvGraphicFramePr>
          <p:nvPr/>
        </p:nvGraphicFramePr>
        <p:xfrm>
          <a:off x="2679400" y="3059113"/>
          <a:ext cx="3128962" cy="21891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6" imgW="4061611" imgH="2954704" progId="Prism8.Document">
                  <p:embed/>
                </p:oleObj>
              </mc:Choice>
              <mc:Fallback>
                <p:oleObj name="Prism 8" r:id="rId6" imgW="4061611" imgH="2954704" progId="Prism8.Document">
                  <p:embed/>
                  <p:pic>
                    <p:nvPicPr>
                      <p:cNvPr id="9" name="개체 8">
                        <a:extLst>
                          <a:ext uri="{FF2B5EF4-FFF2-40B4-BE49-F238E27FC236}">
                            <a16:creationId xmlns:a16="http://schemas.microsoft.com/office/drawing/2014/main" id="{9EE7D44F-78B8-4C56-B4FF-CFA4527088F8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2679400" y="3059113"/>
                        <a:ext cx="3128962" cy="21891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개체 9">
            <a:extLst>
              <a:ext uri="{FF2B5EF4-FFF2-40B4-BE49-F238E27FC236}">
                <a16:creationId xmlns:a16="http://schemas.microsoft.com/office/drawing/2014/main" id="{2D19EFC6-3E72-427A-BB17-AD22B6EDD5F0}"/>
              </a:ext>
            </a:extLst>
          </p:cNvPr>
          <p:cNvGraphicFramePr>
            <a:graphicFrameLocks/>
          </p:cNvGraphicFramePr>
          <p:nvPr/>
        </p:nvGraphicFramePr>
        <p:xfrm>
          <a:off x="5702546" y="3053508"/>
          <a:ext cx="3184525" cy="21939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8" imgW="3988143" imgH="2964068" progId="Prism8.Document">
                  <p:embed/>
                </p:oleObj>
              </mc:Choice>
              <mc:Fallback>
                <p:oleObj name="Prism 8" r:id="rId8" imgW="3988143" imgH="2964068" progId="Prism8.Document">
                  <p:embed/>
                  <p:pic>
                    <p:nvPicPr>
                      <p:cNvPr id="10" name="개체 9">
                        <a:extLst>
                          <a:ext uri="{FF2B5EF4-FFF2-40B4-BE49-F238E27FC236}">
                            <a16:creationId xmlns:a16="http://schemas.microsoft.com/office/drawing/2014/main" id="{2D19EFC6-3E72-427A-BB17-AD22B6EDD5F0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5702546" y="3053508"/>
                        <a:ext cx="3184525" cy="21939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1" name="TextBox 10">
            <a:extLst>
              <a:ext uri="{FF2B5EF4-FFF2-40B4-BE49-F238E27FC236}">
                <a16:creationId xmlns:a16="http://schemas.microsoft.com/office/drawing/2014/main" id="{8DA079B2-D09C-4092-82A3-EE2B2B6D3D89}"/>
              </a:ext>
            </a:extLst>
          </p:cNvPr>
          <p:cNvSpPr txBox="1"/>
          <p:nvPr/>
        </p:nvSpPr>
        <p:spPr>
          <a:xfrm>
            <a:off x="2868744" y="451655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85BA8EC9-E26A-473C-B2D4-D635AFB747F2}"/>
              </a:ext>
            </a:extLst>
          </p:cNvPr>
          <p:cNvSpPr txBox="1"/>
          <p:nvPr/>
        </p:nvSpPr>
        <p:spPr>
          <a:xfrm>
            <a:off x="5963061" y="451655"/>
            <a:ext cx="3898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72D955B3-8D71-48BA-80FE-337B37FA07D5}"/>
              </a:ext>
            </a:extLst>
          </p:cNvPr>
          <p:cNvSpPr txBox="1"/>
          <p:nvPr/>
        </p:nvSpPr>
        <p:spPr>
          <a:xfrm>
            <a:off x="2868744" y="2900765"/>
            <a:ext cx="3898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38948574-B450-4158-AE13-A601BF53C9CD}"/>
              </a:ext>
            </a:extLst>
          </p:cNvPr>
          <p:cNvSpPr txBox="1"/>
          <p:nvPr/>
        </p:nvSpPr>
        <p:spPr>
          <a:xfrm>
            <a:off x="5963061" y="2900765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)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FAFC0D28-C1D9-446F-9FCF-868F55FD9B43}"/>
              </a:ext>
            </a:extLst>
          </p:cNvPr>
          <p:cNvSpPr txBox="1"/>
          <p:nvPr/>
        </p:nvSpPr>
        <p:spPr>
          <a:xfrm>
            <a:off x="280452" y="313155"/>
            <a:ext cx="19915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4. </a:t>
            </a:r>
            <a:r>
              <a:rPr lang="en-US" altLang="ko-KR" sz="1200" dirty="0">
                <a:solidFill>
                  <a:srgbClr val="000000"/>
                </a:solidFill>
                <a:latin typeface="Times New Roman" panose="02020603050405020304" pitchFamily="18" charset="0"/>
                <a:ea typeface="Palatino Linotype" panose="02040502050505030304" pitchFamily="18" charset="0"/>
                <a:cs typeface="Times New Roman" panose="02020603050405020304" pitchFamily="18" charset="0"/>
              </a:rPr>
              <a:t>                                                                                                                                                                                                        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직사각형 1">
            <a:extLst>
              <a:ext uri="{FF2B5EF4-FFF2-40B4-BE49-F238E27FC236}">
                <a16:creationId xmlns:a16="http://schemas.microsoft.com/office/drawing/2014/main" id="{A4E3B76A-85EB-4845-B99D-9BB11D242B6F}"/>
              </a:ext>
            </a:extLst>
          </p:cNvPr>
          <p:cNvSpPr/>
          <p:nvPr/>
        </p:nvSpPr>
        <p:spPr>
          <a:xfrm>
            <a:off x="1512805" y="5365602"/>
            <a:ext cx="9517281" cy="1200329"/>
          </a:xfrm>
          <a:prstGeom prst="rect">
            <a:avLst/>
          </a:prstGeom>
        </p:spPr>
        <p:txBody>
          <a:bodyPr wrap="square" anchor="ctr">
            <a:spAutoFit/>
          </a:bodyPr>
          <a:lstStyle/>
          <a:p>
            <a:pPr algn="just">
              <a:spcAft>
                <a:spcPts val="800"/>
              </a:spcAft>
            </a:pP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4. </a:t>
            </a:r>
            <a:r>
              <a:rPr lang="en-US" altLang="ko-KR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ffects of heat-killed </a:t>
            </a:r>
            <a:r>
              <a:rPr lang="en-GB" altLang="ko-KR" sz="12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. </a:t>
            </a:r>
            <a:r>
              <a:rPr lang="en-GB" altLang="ko-KR" sz="1200" i="1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aracasei</a:t>
            </a:r>
            <a:r>
              <a:rPr lang="en-GB" altLang="ko-KR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TG-E1 on gut barrier function in the ileum of </a:t>
            </a:r>
            <a:r>
              <a:rPr lang="en-US" altLang="ko-KR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 PM</a:t>
            </a:r>
            <a:r>
              <a:rPr lang="en-US" altLang="ko-KR" sz="1200" kern="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US" altLang="ko-KR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-induced airway inflammation animal model. </a:t>
            </a:r>
            <a:r>
              <a:rPr lang="en-GB" altLang="ko-KR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</a:t>
            </a:r>
            <a:r>
              <a:rPr lang="en-GB" altLang="ko-KR" sz="1200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ccludin</a:t>
            </a:r>
            <a:r>
              <a:rPr lang="en-GB" altLang="ko-KR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(B) Claudin-1, (C) Claudin-4, and (D) Claudin-5 gene expression levels in the ileum. NC: BALB/c normal mice; CTL: PM</a:t>
            </a:r>
            <a:r>
              <a:rPr lang="en-GB" altLang="ko-KR" sz="1200" kern="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GB" altLang="ko-KR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-sensitized control mice; </a:t>
            </a:r>
            <a:r>
              <a:rPr lang="en-GB" altLang="ko-KR" sz="1200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xa</a:t>
            </a:r>
            <a:r>
              <a:rPr lang="en-GB" altLang="ko-KR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3 mg/kg dexamethasone-treated PM</a:t>
            </a:r>
            <a:r>
              <a:rPr lang="en-GB" altLang="ko-KR" sz="1200" kern="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GB" altLang="ko-KR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-sensitized mice; H: total cell number 1 X 10</a:t>
            </a:r>
            <a:r>
              <a:rPr lang="en-GB" altLang="ko-KR" sz="1200" kern="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GB" altLang="ko-KR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/day heat-killed of </a:t>
            </a:r>
            <a:r>
              <a:rPr lang="en-GB" altLang="ko-KR" sz="12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. </a:t>
            </a:r>
            <a:r>
              <a:rPr lang="en-GB" altLang="ko-KR" sz="1200" i="1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aracasei</a:t>
            </a:r>
            <a:r>
              <a:rPr lang="en-GB" altLang="ko-KR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TG-E1-treated PM</a:t>
            </a:r>
            <a:r>
              <a:rPr lang="en-GB" altLang="ko-KR" sz="1200" kern="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GB" altLang="ko-KR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-sensitized mice; M: total cell number 1 X 10</a:t>
            </a:r>
            <a:r>
              <a:rPr lang="en-GB" altLang="ko-KR" sz="1200" kern="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</a:t>
            </a:r>
            <a:r>
              <a:rPr lang="en-GB" altLang="ko-KR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day heat-killed of </a:t>
            </a:r>
            <a:r>
              <a:rPr lang="en-GB" altLang="ko-KR" sz="12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. </a:t>
            </a:r>
            <a:r>
              <a:rPr lang="en-GB" altLang="ko-KR" sz="1200" i="1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aracasei</a:t>
            </a:r>
            <a:r>
              <a:rPr lang="en-GB" altLang="ko-KR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TG-E1-treated PM</a:t>
            </a:r>
            <a:r>
              <a:rPr lang="en-GB" altLang="ko-KR" sz="1200" kern="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GB" altLang="ko-KR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-sensitized mice; L: total cell number 1 X 10</a:t>
            </a:r>
            <a:r>
              <a:rPr lang="en-GB" altLang="ko-KR" sz="1200" kern="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r>
              <a:rPr lang="en-GB" altLang="ko-KR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day heat-killed of </a:t>
            </a:r>
            <a:r>
              <a:rPr lang="en-GB" altLang="ko-KR" sz="12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. </a:t>
            </a:r>
            <a:r>
              <a:rPr lang="en-GB" altLang="ko-KR" sz="1200" i="1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aracasei</a:t>
            </a:r>
            <a:r>
              <a:rPr lang="en-GB" altLang="ko-KR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TG-E1-treated PM</a:t>
            </a:r>
            <a:r>
              <a:rPr lang="en-GB" altLang="ko-KR" sz="1200" kern="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GB" altLang="ko-KR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-sensitized mice. Data are expressed as the mean ± SEM (n = 8). </a:t>
            </a:r>
            <a:r>
              <a:rPr lang="en-GB" altLang="ko-KR" sz="1200" kern="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#</a:t>
            </a:r>
            <a:r>
              <a:rPr lang="en-GB" altLang="ko-KR" sz="12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</a:t>
            </a:r>
            <a:r>
              <a:rPr lang="en-GB" altLang="ko-KR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 0.05 vs NC; </a:t>
            </a:r>
            <a:r>
              <a:rPr lang="en-GB" altLang="ko-KR" sz="1200" kern="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**</a:t>
            </a:r>
            <a:r>
              <a:rPr lang="en-GB" altLang="ko-KR" sz="12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</a:t>
            </a:r>
            <a:r>
              <a:rPr lang="en-GB" altLang="ko-KR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 0.0001 vs CTL. </a:t>
            </a:r>
            <a:endParaRPr lang="ko-KR" altLang="ko-KR" sz="1200" kern="100" dirty="0">
              <a:latin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6363486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개체 1">
            <a:extLst>
              <a:ext uri="{FF2B5EF4-FFF2-40B4-BE49-F238E27FC236}">
                <a16:creationId xmlns:a16="http://schemas.microsoft.com/office/drawing/2014/main" id="{5FFF87CF-4751-45A0-E5EC-ABFA7143966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52238374"/>
              </p:ext>
            </p:extLst>
          </p:nvPr>
        </p:nvGraphicFramePr>
        <p:xfrm>
          <a:off x="6346825" y="1812540"/>
          <a:ext cx="4117975" cy="24447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" imgW="4084299" imgH="2707638" progId="Prism8.Document">
                  <p:embed/>
                </p:oleObj>
              </mc:Choice>
              <mc:Fallback>
                <p:oleObj name="Prism 8" r:id="rId2" imgW="4084299" imgH="2707638" progId="Prism8.Document">
                  <p:embed/>
                  <p:pic>
                    <p:nvPicPr>
                      <p:cNvPr id="2" name="개체 1">
                        <a:extLst>
                          <a:ext uri="{FF2B5EF4-FFF2-40B4-BE49-F238E27FC236}">
                            <a16:creationId xmlns:a16="http://schemas.microsoft.com/office/drawing/2014/main" id="{5FFF87CF-4751-45A0-E5EC-ABFA7143966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6346825" y="1812540"/>
                        <a:ext cx="4117975" cy="24447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CAD546EA-5EDF-46EA-BAFA-CE172F247DF0}"/>
              </a:ext>
            </a:extLst>
          </p:cNvPr>
          <p:cNvSpPr txBox="1"/>
          <p:nvPr/>
        </p:nvSpPr>
        <p:spPr>
          <a:xfrm>
            <a:off x="353686" y="336430"/>
            <a:ext cx="18373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5. 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29" name="개체 28">
            <a:extLst>
              <a:ext uri="{FF2B5EF4-FFF2-40B4-BE49-F238E27FC236}">
                <a16:creationId xmlns:a16="http://schemas.microsoft.com/office/drawing/2014/main" id="{D09F73FB-B614-4988-ACEB-7CCCA140259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81100913"/>
              </p:ext>
            </p:extLst>
          </p:nvPr>
        </p:nvGraphicFramePr>
        <p:xfrm>
          <a:off x="1309688" y="1635125"/>
          <a:ext cx="4775200" cy="24431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4" imgW="4775039" imgH="2442565" progId="Prism8.Document">
                  <p:embed/>
                </p:oleObj>
              </mc:Choice>
              <mc:Fallback>
                <p:oleObj name="Prism 8" r:id="rId4" imgW="4775039" imgH="2442565" progId="Prism8.Document">
                  <p:embed/>
                  <p:pic>
                    <p:nvPicPr>
                      <p:cNvPr id="29" name="개체 28">
                        <a:extLst>
                          <a:ext uri="{FF2B5EF4-FFF2-40B4-BE49-F238E27FC236}">
                            <a16:creationId xmlns:a16="http://schemas.microsoft.com/office/drawing/2014/main" id="{D09F73FB-B614-4988-ACEB-7CCCA140259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309688" y="1635125"/>
                        <a:ext cx="4775200" cy="24431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FD1AEFDC-560A-4963-8DF1-4CE8E3FB1153}"/>
              </a:ext>
            </a:extLst>
          </p:cNvPr>
          <p:cNvSpPr txBox="1"/>
          <p:nvPr/>
        </p:nvSpPr>
        <p:spPr>
          <a:xfrm>
            <a:off x="2057860" y="1480364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70A6D5C7-F208-4F45-8F76-E4EFCC308663}"/>
              </a:ext>
            </a:extLst>
          </p:cNvPr>
          <p:cNvSpPr txBox="1"/>
          <p:nvPr/>
        </p:nvSpPr>
        <p:spPr>
          <a:xfrm>
            <a:off x="7058614" y="1480364"/>
            <a:ext cx="3898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5B6E866-52DB-4D96-BF96-93553EC9CCB4}"/>
              </a:ext>
            </a:extLst>
          </p:cNvPr>
          <p:cNvSpPr txBox="1"/>
          <p:nvPr/>
        </p:nvSpPr>
        <p:spPr>
          <a:xfrm>
            <a:off x="1792767" y="4662638"/>
            <a:ext cx="8433786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5. Effects of </a:t>
            </a:r>
            <a:r>
              <a:rPr lang="ko-KR" altLang="ko-KR" sz="1200" dirty="0">
                <a:solidFill>
                  <a:srgbClr val="000000"/>
                </a:solidFill>
                <a:latin typeface="Times New Roman" panose="02020603050405020304" pitchFamily="18" charset="0"/>
                <a:ea typeface="Palatino Linotype" panose="02040502050505030304" pitchFamily="18" charset="0"/>
                <a:cs typeface="Times New Roman" panose="02020603050405020304" pitchFamily="18" charset="0"/>
              </a:rPr>
              <a:t>of </a:t>
            </a:r>
            <a:r>
              <a:rPr lang="en-US" altLang="ko-KR" sz="1200" dirty="0">
                <a:solidFill>
                  <a:srgbClr val="000000"/>
                </a:solidFill>
                <a:latin typeface="Times New Roman" panose="02020603050405020304" pitchFamily="18" charset="0"/>
                <a:ea typeface="Palatino Linotype" panose="02040502050505030304" pitchFamily="18" charset="0"/>
                <a:cs typeface="Times New Roman" panose="02020603050405020304" pitchFamily="18" charset="0"/>
              </a:rPr>
              <a:t>Heat-killed </a:t>
            </a:r>
            <a:r>
              <a:rPr lang="en-US" altLang="ko-KR" sz="1200" i="1" dirty="0">
                <a:solidFill>
                  <a:srgbClr val="000000"/>
                </a:solidFill>
                <a:latin typeface="Times New Roman" panose="02020603050405020304" pitchFamily="18" charset="0"/>
                <a:ea typeface="Palatino Linotype" panose="02040502050505030304" pitchFamily="18" charset="0"/>
                <a:cs typeface="Times New Roman" panose="02020603050405020304" pitchFamily="18" charset="0"/>
              </a:rPr>
              <a:t>L. </a:t>
            </a:r>
            <a:r>
              <a:rPr lang="en-US" altLang="ko-KR" sz="1200" i="1" dirty="0" err="1">
                <a:solidFill>
                  <a:srgbClr val="000000"/>
                </a:solidFill>
                <a:latin typeface="Times New Roman" panose="02020603050405020304" pitchFamily="18" charset="0"/>
                <a:ea typeface="Palatino Linotype" panose="02040502050505030304" pitchFamily="18" charset="0"/>
                <a:cs typeface="Times New Roman" panose="02020603050405020304" pitchFamily="18" charset="0"/>
              </a:rPr>
              <a:t>paracasei</a:t>
            </a:r>
            <a:r>
              <a:rPr lang="en-US" altLang="ko-KR" sz="1200" i="1" dirty="0">
                <a:solidFill>
                  <a:srgbClr val="000000"/>
                </a:solidFill>
                <a:latin typeface="Times New Roman" panose="02020603050405020304" pitchFamily="18" charset="0"/>
                <a:ea typeface="Palatino Linotype" panose="0204050205050503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200" dirty="0">
                <a:solidFill>
                  <a:srgbClr val="000000"/>
                </a:solidFill>
                <a:latin typeface="Times New Roman" panose="02020603050405020304" pitchFamily="18" charset="0"/>
                <a:ea typeface="Palatino Linotype" panose="02040502050505030304" pitchFamily="18" charset="0"/>
                <a:cs typeface="Times New Roman" panose="02020603050405020304" pitchFamily="18" charset="0"/>
              </a:rPr>
              <a:t>ATG-E1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n</a:t>
            </a:r>
            <a:r>
              <a:rPr lang="en-US" altLang="ko-KR" sz="1200" dirty="0">
                <a:solidFill>
                  <a:srgbClr val="000000"/>
                </a:solidFill>
                <a:latin typeface="Times New Roman" panose="02020603050405020304" pitchFamily="18" charset="0"/>
                <a:ea typeface="Palatino Linotype" panose="0204050205050503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mmune cell number </a:t>
            </a:r>
            <a:r>
              <a:rPr lang="en-US" altLang="ko-KR" sz="1200" dirty="0">
                <a:solidFill>
                  <a:srgbClr val="000000"/>
                </a:solidFill>
                <a:latin typeface="Times New Roman" panose="02020603050405020304" pitchFamily="18" charset="0"/>
                <a:ea typeface="Palatino Linotype" panose="02040502050505030304" pitchFamily="18" charset="0"/>
                <a:cs typeface="Times New Roman" panose="02020603050405020304" pitchFamily="18" charset="0"/>
              </a:rPr>
              <a:t>in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yer’s patch of a PM</a:t>
            </a:r>
            <a:r>
              <a:rPr lang="en-US" altLang="ko-KR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-induced airway inflammation animal model.</a:t>
            </a:r>
            <a:r>
              <a:rPr lang="en-US" altLang="ko-KR" sz="1200" dirty="0">
                <a:solidFill>
                  <a:srgbClr val="000000"/>
                </a:solidFill>
                <a:latin typeface="Times New Roman" panose="02020603050405020304" pitchFamily="18" charset="0"/>
                <a:ea typeface="Palatino Linotype" panose="02040502050505030304" pitchFamily="18" charset="0"/>
                <a:cs typeface="Times New Roman" panose="02020603050405020304" pitchFamily="18" charset="0"/>
              </a:rPr>
              <a:t> </a:t>
            </a:r>
            <a:r>
              <a:rPr lang="en-GB" altLang="ko-KR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</a:t>
            </a:r>
            <a:r>
              <a:rPr lang="en-US" altLang="ko-KR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4</a:t>
            </a:r>
            <a:r>
              <a:rPr lang="en-US" altLang="ko-KR" sz="1200" kern="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ko-KR" altLang="en-US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CD8</a:t>
            </a:r>
            <a:r>
              <a:rPr lang="en-US" altLang="ko-KR" sz="1200" kern="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altLang="ko-KR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bsolute number and </a:t>
            </a:r>
            <a:r>
              <a:rPr lang="en-GB" altLang="ko-KR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B) CD4</a:t>
            </a:r>
            <a:r>
              <a:rPr lang="en-GB" altLang="ko-KR" sz="1200" kern="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GB" altLang="ko-KR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69</a:t>
            </a:r>
            <a:r>
              <a:rPr lang="en-GB" altLang="ko-KR" sz="1200" kern="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</a:t>
            </a:r>
            <a:r>
              <a:rPr lang="en-GB" altLang="ko-KR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bsolute number in the </a:t>
            </a:r>
            <a:r>
              <a:rPr lang="en-GB" altLang="ko-KR" sz="1200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eyer’s</a:t>
            </a:r>
            <a:r>
              <a:rPr lang="en-GB" altLang="ko-KR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atch. NC: BALB/c normal mice; CTL: PM</a:t>
            </a:r>
            <a:r>
              <a:rPr lang="en-GB" altLang="ko-KR" sz="1200" kern="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GB" altLang="ko-KR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-sensitized control mice; </a:t>
            </a:r>
            <a:r>
              <a:rPr lang="en-GB" altLang="ko-KR" sz="1200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xa</a:t>
            </a:r>
            <a:r>
              <a:rPr lang="en-GB" altLang="ko-KR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3 mg/kg dexamethasone-treated PM</a:t>
            </a:r>
            <a:r>
              <a:rPr lang="en-GB" altLang="ko-KR" sz="1200" kern="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GB" altLang="ko-KR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-sensitized mice; H: total cell number 1 X 10</a:t>
            </a:r>
            <a:r>
              <a:rPr lang="en-GB" altLang="ko-KR" sz="1200" kern="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GB" altLang="ko-KR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/day heat-killed of </a:t>
            </a:r>
            <a:r>
              <a:rPr lang="en-GB" altLang="ko-KR" sz="12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. </a:t>
            </a:r>
            <a:r>
              <a:rPr lang="en-GB" altLang="ko-KR" sz="1200" i="1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aracasei</a:t>
            </a:r>
            <a:r>
              <a:rPr lang="en-GB" altLang="ko-KR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TG-E1-treated PM</a:t>
            </a:r>
            <a:r>
              <a:rPr lang="en-GB" altLang="ko-KR" sz="1200" kern="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GB" altLang="ko-KR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-sensitized mice; M: total cell number 1 X 10</a:t>
            </a:r>
            <a:r>
              <a:rPr lang="en-GB" altLang="ko-KR" sz="1200" kern="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</a:t>
            </a:r>
            <a:r>
              <a:rPr lang="en-GB" altLang="ko-KR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day heat-killed of </a:t>
            </a:r>
            <a:r>
              <a:rPr lang="en-GB" altLang="ko-KR" sz="12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. </a:t>
            </a:r>
            <a:r>
              <a:rPr lang="en-GB" altLang="ko-KR" sz="1200" i="1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aracasei</a:t>
            </a:r>
            <a:r>
              <a:rPr lang="en-GB" altLang="ko-KR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TG-E1-treated PM</a:t>
            </a:r>
            <a:r>
              <a:rPr lang="en-GB" altLang="ko-KR" sz="1200" kern="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GB" altLang="ko-KR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-sensitized mice; L: total cell number 1 X 10</a:t>
            </a:r>
            <a:r>
              <a:rPr lang="en-GB" altLang="ko-KR" sz="1200" kern="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r>
              <a:rPr lang="en-GB" altLang="ko-KR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day heat-killed of </a:t>
            </a:r>
            <a:r>
              <a:rPr lang="en-GB" altLang="ko-KR" sz="12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. </a:t>
            </a:r>
            <a:r>
              <a:rPr lang="en-GB" altLang="ko-KR" sz="1200" i="1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aracasei</a:t>
            </a:r>
            <a:r>
              <a:rPr lang="en-GB" altLang="ko-KR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TG-E1-treated PM</a:t>
            </a:r>
            <a:r>
              <a:rPr lang="en-GB" altLang="ko-KR" sz="1200" kern="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GB" altLang="ko-KR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-sensitized mice. Data are expressed as the mean ± SEM (n = 8). </a:t>
            </a:r>
            <a:r>
              <a:rPr lang="en-GB" altLang="ko-KR" sz="1200" kern="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#</a:t>
            </a:r>
            <a:r>
              <a:rPr lang="en-GB" altLang="ko-KR" sz="12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</a:t>
            </a:r>
            <a:r>
              <a:rPr lang="en-GB" altLang="ko-KR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 0.05 vs NC; </a:t>
            </a:r>
            <a:r>
              <a:rPr lang="en-GB" altLang="ko-KR" sz="1200" kern="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r>
              <a:rPr lang="en-GB" altLang="ko-KR" sz="12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</a:t>
            </a:r>
            <a:r>
              <a:rPr lang="en-GB" altLang="ko-KR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 0.05 vs CTL. </a:t>
            </a:r>
            <a:r>
              <a:rPr lang="en-US" altLang="ko-KR" sz="1200" dirty="0">
                <a:solidFill>
                  <a:srgbClr val="000000"/>
                </a:solidFill>
                <a:latin typeface="Times New Roman" panose="02020603050405020304" pitchFamily="18" charset="0"/>
                <a:ea typeface="Palatino Linotype" panose="02040502050505030304" pitchFamily="18" charset="0"/>
                <a:cs typeface="Times New Roman" panose="02020603050405020304" pitchFamily="18" charset="0"/>
              </a:rPr>
              <a:t>                                                                 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7091698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90F518E3-1C2B-E3A4-8B87-D55EF8C98A0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C77EA1E6-08D5-08FF-790B-52092A005A88}"/>
              </a:ext>
            </a:extLst>
          </p:cNvPr>
          <p:cNvSpPr txBox="1"/>
          <p:nvPr/>
        </p:nvSpPr>
        <p:spPr>
          <a:xfrm>
            <a:off x="353686" y="336430"/>
            <a:ext cx="18373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6. 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184445E-4EB4-3BD5-262A-9833CA263A8D}"/>
              </a:ext>
            </a:extLst>
          </p:cNvPr>
          <p:cNvSpPr txBox="1"/>
          <p:nvPr/>
        </p:nvSpPr>
        <p:spPr>
          <a:xfrm>
            <a:off x="1490668" y="4633656"/>
            <a:ext cx="9544017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6. Effects of </a:t>
            </a:r>
            <a:r>
              <a:rPr lang="ko-KR" altLang="ko-KR" sz="1200" dirty="0">
                <a:solidFill>
                  <a:srgbClr val="000000"/>
                </a:solidFill>
                <a:latin typeface="Times New Roman" panose="02020603050405020304" pitchFamily="18" charset="0"/>
                <a:ea typeface="Palatino Linotype" panose="02040502050505030304" pitchFamily="18" charset="0"/>
                <a:cs typeface="Times New Roman" panose="02020603050405020304" pitchFamily="18" charset="0"/>
              </a:rPr>
              <a:t>of </a:t>
            </a:r>
            <a:r>
              <a:rPr lang="en-US" altLang="ko-KR" sz="1200" dirty="0">
                <a:solidFill>
                  <a:srgbClr val="000000"/>
                </a:solidFill>
                <a:latin typeface="Times New Roman" panose="02020603050405020304" pitchFamily="18" charset="0"/>
                <a:ea typeface="Palatino Linotype" panose="02040502050505030304" pitchFamily="18" charset="0"/>
                <a:cs typeface="Times New Roman" panose="02020603050405020304" pitchFamily="18" charset="0"/>
              </a:rPr>
              <a:t>live</a:t>
            </a:r>
            <a:r>
              <a:rPr lang="ko-KR" alt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Palatino Linotype" panose="0204050205050503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200" dirty="0">
                <a:solidFill>
                  <a:srgbClr val="000000"/>
                </a:solidFill>
                <a:latin typeface="Times New Roman" panose="02020603050405020304" pitchFamily="18" charset="0"/>
                <a:ea typeface="Palatino Linotype" panose="02040502050505030304" pitchFamily="18" charset="0"/>
                <a:cs typeface="Times New Roman" panose="02020603050405020304" pitchFamily="18" charset="0"/>
              </a:rPr>
              <a:t>and</a:t>
            </a:r>
            <a:r>
              <a:rPr lang="ko-KR" alt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Palatino Linotype" panose="0204050205050503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200" dirty="0">
                <a:solidFill>
                  <a:srgbClr val="000000"/>
                </a:solidFill>
                <a:latin typeface="Times New Roman" panose="02020603050405020304" pitchFamily="18" charset="0"/>
                <a:ea typeface="Palatino Linotype" panose="02040502050505030304" pitchFamily="18" charset="0"/>
                <a:cs typeface="Times New Roman" panose="02020603050405020304" pitchFamily="18" charset="0"/>
              </a:rPr>
              <a:t>heat-killed </a:t>
            </a:r>
            <a:r>
              <a:rPr lang="en-US" altLang="ko-KR" sz="1200" i="1" dirty="0">
                <a:solidFill>
                  <a:srgbClr val="000000"/>
                </a:solidFill>
                <a:latin typeface="Times New Roman" panose="02020603050405020304" pitchFamily="18" charset="0"/>
                <a:ea typeface="Palatino Linotype" panose="02040502050505030304" pitchFamily="18" charset="0"/>
                <a:cs typeface="Times New Roman" panose="02020603050405020304" pitchFamily="18" charset="0"/>
              </a:rPr>
              <a:t>L. </a:t>
            </a:r>
            <a:r>
              <a:rPr lang="en-US" altLang="ko-KR" sz="1200" i="1" dirty="0" err="1">
                <a:solidFill>
                  <a:srgbClr val="000000"/>
                </a:solidFill>
                <a:latin typeface="Times New Roman" panose="02020603050405020304" pitchFamily="18" charset="0"/>
                <a:ea typeface="Palatino Linotype" panose="02040502050505030304" pitchFamily="18" charset="0"/>
                <a:cs typeface="Times New Roman" panose="02020603050405020304" pitchFamily="18" charset="0"/>
              </a:rPr>
              <a:t>paracasei</a:t>
            </a:r>
            <a:r>
              <a:rPr lang="en-US" altLang="ko-KR" sz="1200" i="1" dirty="0">
                <a:solidFill>
                  <a:srgbClr val="000000"/>
                </a:solidFill>
                <a:latin typeface="Times New Roman" panose="02020603050405020304" pitchFamily="18" charset="0"/>
                <a:ea typeface="Palatino Linotype" panose="0204050205050503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200" dirty="0">
                <a:solidFill>
                  <a:srgbClr val="000000"/>
                </a:solidFill>
                <a:latin typeface="Times New Roman" panose="02020603050405020304" pitchFamily="18" charset="0"/>
                <a:ea typeface="Palatino Linotype" panose="02040502050505030304" pitchFamily="18" charset="0"/>
                <a:cs typeface="Times New Roman" panose="02020603050405020304" pitchFamily="18" charset="0"/>
              </a:rPr>
              <a:t>ATG-E1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n</a:t>
            </a:r>
            <a:r>
              <a:rPr lang="en-US" altLang="ko-KR" sz="1200" dirty="0">
                <a:solidFill>
                  <a:srgbClr val="000000"/>
                </a:solidFill>
                <a:latin typeface="Times New Roman" panose="02020603050405020304" pitchFamily="18" charset="0"/>
                <a:ea typeface="Palatino Linotype" panose="02040502050505030304" pitchFamily="18" charset="0"/>
                <a:cs typeface="Times New Roman" panose="02020603050405020304" pitchFamily="18" charset="0"/>
              </a:rPr>
              <a:t> cytokines in BALF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 PM</a:t>
            </a:r>
            <a:r>
              <a:rPr lang="en-US" altLang="ko-KR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-induced airway inflammation animal model.</a:t>
            </a:r>
            <a:r>
              <a:rPr lang="en-US" altLang="ko-KR" sz="1200" dirty="0">
                <a:solidFill>
                  <a:srgbClr val="000000"/>
                </a:solidFill>
                <a:latin typeface="Times New Roman" panose="02020603050405020304" pitchFamily="18" charset="0"/>
                <a:ea typeface="Palatino Linotype" panose="02040502050505030304" pitchFamily="18" charset="0"/>
                <a:cs typeface="Times New Roman" panose="02020603050405020304" pitchFamily="18" charset="0"/>
              </a:rPr>
              <a:t> </a:t>
            </a:r>
            <a:r>
              <a:rPr lang="en-GB" altLang="ko-KR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XCL-1,</a:t>
            </a:r>
            <a:r>
              <a:rPr lang="en-US" altLang="ko-KR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altLang="ko-KR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P-2, and (C) IL-1</a:t>
            </a:r>
            <a:r>
              <a:rPr lang="el-GR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GB" altLang="ko-KR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C: BALB/c normal mice; CTL: PM</a:t>
            </a:r>
            <a:r>
              <a:rPr lang="en-GB" altLang="ko-KR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GB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-sensitized control mice; </a:t>
            </a:r>
            <a:r>
              <a:rPr lang="en-GB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xa</a:t>
            </a:r>
            <a:r>
              <a:rPr lang="en-GB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3 mg/kg dexamethasone-treated PM</a:t>
            </a:r>
            <a:r>
              <a:rPr lang="en-GB" altLang="ko-KR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GB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-sensitized mice; LH: 1 X 10</a:t>
            </a:r>
            <a:r>
              <a:rPr lang="en-GB" altLang="ko-KR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GB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FU/day of live </a:t>
            </a:r>
            <a:r>
              <a:rPr lang="en-GB" altLang="ko-KR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. </a:t>
            </a:r>
            <a:r>
              <a:rPr lang="en-GB" altLang="ko-KR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aracasei</a:t>
            </a:r>
            <a:r>
              <a:rPr lang="en-GB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TG-E1-treated PM</a:t>
            </a:r>
            <a:r>
              <a:rPr lang="en-GB" altLang="ko-KR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GB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-sensitized mice, DH: total cell number 1 X 10</a:t>
            </a:r>
            <a:r>
              <a:rPr lang="en-GB" altLang="ko-KR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GB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/day heat-killed of </a:t>
            </a:r>
            <a:r>
              <a:rPr lang="en-GB" altLang="ko-KR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. </a:t>
            </a:r>
            <a:r>
              <a:rPr lang="en-GB" altLang="ko-KR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aracasei</a:t>
            </a:r>
            <a:r>
              <a:rPr lang="en-GB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TG-E1-treated PM</a:t>
            </a:r>
            <a:r>
              <a:rPr lang="en-GB" altLang="ko-KR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GB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-sensitized mice, DM: total cell number 1 X 10</a:t>
            </a:r>
            <a:r>
              <a:rPr lang="en-GB" altLang="ko-KR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</a:t>
            </a:r>
            <a:r>
              <a:rPr lang="en-GB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day heat-killed of </a:t>
            </a:r>
            <a:r>
              <a:rPr lang="en-GB" altLang="ko-KR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. </a:t>
            </a:r>
            <a:r>
              <a:rPr lang="en-GB" altLang="ko-KR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aracasei</a:t>
            </a:r>
            <a:r>
              <a:rPr lang="en-GB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TG-E1-treated PM</a:t>
            </a:r>
            <a:r>
              <a:rPr lang="en-GB" altLang="ko-KR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GB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-sensitized mice, DL: total cell number 1 X 10</a:t>
            </a:r>
            <a:r>
              <a:rPr lang="en-GB" altLang="ko-KR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r>
              <a:rPr lang="en-GB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day heat-killed of </a:t>
            </a:r>
            <a:r>
              <a:rPr lang="en-GB" altLang="ko-KR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. </a:t>
            </a:r>
            <a:r>
              <a:rPr lang="en-GB" altLang="ko-KR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aracasei</a:t>
            </a:r>
            <a:r>
              <a:rPr lang="en-GB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TG-E1-treated PM</a:t>
            </a:r>
            <a:r>
              <a:rPr lang="en-GB" altLang="ko-KR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GB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-sensitized mice. Data are expressed as the mean ± SEM (n = 8).  </a:t>
            </a:r>
            <a:r>
              <a:rPr lang="en-GB" altLang="ko-KR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###</a:t>
            </a:r>
            <a:r>
              <a:rPr lang="en-GB" altLang="ko-KR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GB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0.005 vs NC; </a:t>
            </a:r>
            <a:r>
              <a:rPr lang="en-GB" altLang="ko-KR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</a:t>
            </a:r>
            <a:r>
              <a:rPr lang="en-GB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 0.05, </a:t>
            </a:r>
            <a:r>
              <a:rPr lang="en-GB" altLang="ko-KR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  <a:r>
              <a:rPr lang="en-GB" altLang="ko-KR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</a:t>
            </a:r>
            <a:r>
              <a:rPr lang="en-GB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 0.01, and </a:t>
            </a:r>
            <a:r>
              <a:rPr lang="en-GB" altLang="ko-KR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*</a:t>
            </a:r>
            <a:r>
              <a:rPr lang="en-GB" altLang="ko-KR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</a:t>
            </a:r>
            <a:r>
              <a:rPr lang="en-GB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 0.005 vs CTL. </a:t>
            </a:r>
            <a:endParaRPr lang="ko-KR" altLang="ko-KR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4" name="개체 3">
            <a:extLst>
              <a:ext uri="{FF2B5EF4-FFF2-40B4-BE49-F238E27FC236}">
                <a16:creationId xmlns:a16="http://schemas.microsoft.com/office/drawing/2014/main" id="{2AB6F91C-5DE8-192D-20FE-60F41F9C143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92590436"/>
              </p:ext>
            </p:extLst>
          </p:nvPr>
        </p:nvGraphicFramePr>
        <p:xfrm>
          <a:off x="1191900" y="1349823"/>
          <a:ext cx="3397250" cy="23399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" imgW="4308304" imgH="2749056" progId="Prism8.Document">
                  <p:embed/>
                </p:oleObj>
              </mc:Choice>
              <mc:Fallback>
                <p:oleObj name="Prism 8" r:id="rId2" imgW="4308304" imgH="2749056" progId="Prism8.Document">
                  <p:embed/>
                  <p:pic>
                    <p:nvPicPr>
                      <p:cNvPr id="18" name="개체 17">
                        <a:extLst>
                          <a:ext uri="{FF2B5EF4-FFF2-40B4-BE49-F238E27FC236}">
                            <a16:creationId xmlns:a16="http://schemas.microsoft.com/office/drawing/2014/main" id="{EF70D6E6-C6A9-4E93-A3AF-A4EF6EED2E73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191900" y="1349823"/>
                        <a:ext cx="3397250" cy="23399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개체 9">
            <a:extLst>
              <a:ext uri="{FF2B5EF4-FFF2-40B4-BE49-F238E27FC236}">
                <a16:creationId xmlns:a16="http://schemas.microsoft.com/office/drawing/2014/main" id="{0FE572B1-A0AA-C751-24EF-056AC4E4560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39662095"/>
              </p:ext>
            </p:extLst>
          </p:nvPr>
        </p:nvGraphicFramePr>
        <p:xfrm>
          <a:off x="4560877" y="1372048"/>
          <a:ext cx="3403600" cy="23320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4" imgW="4463882" imgH="2719883" progId="Prism8.Document">
                  <p:embed/>
                </p:oleObj>
              </mc:Choice>
              <mc:Fallback>
                <p:oleObj name="Prism 8" r:id="rId4" imgW="4463882" imgH="2719883" progId="Prism8.Document">
                  <p:embed/>
                  <p:pic>
                    <p:nvPicPr>
                      <p:cNvPr id="19" name="개체 18">
                        <a:extLst>
                          <a:ext uri="{FF2B5EF4-FFF2-40B4-BE49-F238E27FC236}">
                            <a16:creationId xmlns:a16="http://schemas.microsoft.com/office/drawing/2014/main" id="{6DE85828-81BE-4A59-9357-5B1520858F58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4560877" y="1372048"/>
                        <a:ext cx="3403600" cy="23320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개체 11">
            <a:extLst>
              <a:ext uri="{FF2B5EF4-FFF2-40B4-BE49-F238E27FC236}">
                <a16:creationId xmlns:a16="http://schemas.microsoft.com/office/drawing/2014/main" id="{5C1C1E74-809E-3B34-2F76-AFA1643B3A3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46983510"/>
              </p:ext>
            </p:extLst>
          </p:nvPr>
        </p:nvGraphicFramePr>
        <p:xfrm>
          <a:off x="8160489" y="1355368"/>
          <a:ext cx="3408363" cy="23320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6" imgW="3901350" imgH="2703316" progId="Prism8.Document">
                  <p:embed/>
                </p:oleObj>
              </mc:Choice>
              <mc:Fallback>
                <p:oleObj name="Prism 8" r:id="rId6" imgW="3901350" imgH="2703316" progId="Prism8.Document">
                  <p:embed/>
                  <p:pic>
                    <p:nvPicPr>
                      <p:cNvPr id="22" name="개체 21">
                        <a:extLst>
                          <a:ext uri="{FF2B5EF4-FFF2-40B4-BE49-F238E27FC236}">
                            <a16:creationId xmlns:a16="http://schemas.microsoft.com/office/drawing/2014/main" id="{FAF7A8B2-B132-45C0-9E7B-A8138AD53F8F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8160489" y="1355368"/>
                        <a:ext cx="3408363" cy="23320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4" name="TextBox 13">
            <a:extLst>
              <a:ext uri="{FF2B5EF4-FFF2-40B4-BE49-F238E27FC236}">
                <a16:creationId xmlns:a16="http://schemas.microsoft.com/office/drawing/2014/main" id="{FA831F04-4ACB-C342-ADD2-D33EF3A27361}"/>
              </a:ext>
            </a:extLst>
          </p:cNvPr>
          <p:cNvSpPr txBox="1"/>
          <p:nvPr/>
        </p:nvSpPr>
        <p:spPr>
          <a:xfrm>
            <a:off x="1560390" y="1219261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D5A99FF0-FF6F-5BB8-132B-982C116705B1}"/>
              </a:ext>
            </a:extLst>
          </p:cNvPr>
          <p:cNvSpPr txBox="1"/>
          <p:nvPr/>
        </p:nvSpPr>
        <p:spPr>
          <a:xfrm>
            <a:off x="4975510" y="1231316"/>
            <a:ext cx="3898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021911B1-C994-3FBA-EF0E-F3652F72AB93}"/>
              </a:ext>
            </a:extLst>
          </p:cNvPr>
          <p:cNvSpPr txBox="1"/>
          <p:nvPr/>
        </p:nvSpPr>
        <p:spPr>
          <a:xfrm>
            <a:off x="8499735" y="1211323"/>
            <a:ext cx="3898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8285754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CAD546EA-5EDF-46EA-BAFA-CE172F247DF0}"/>
              </a:ext>
            </a:extLst>
          </p:cNvPr>
          <p:cNvSpPr txBox="1"/>
          <p:nvPr/>
        </p:nvSpPr>
        <p:spPr>
          <a:xfrm>
            <a:off x="353686" y="336430"/>
            <a:ext cx="18758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 Figure S7. 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" name="직선 연결선 5">
            <a:extLst>
              <a:ext uri="{FF2B5EF4-FFF2-40B4-BE49-F238E27FC236}">
                <a16:creationId xmlns:a16="http://schemas.microsoft.com/office/drawing/2014/main" id="{B602D218-4DB3-49E0-B649-B7C9DE18A6B7}"/>
              </a:ext>
            </a:extLst>
          </p:cNvPr>
          <p:cNvCxnSpPr/>
          <p:nvPr/>
        </p:nvCxnSpPr>
        <p:spPr>
          <a:xfrm>
            <a:off x="4666502" y="1657208"/>
            <a:ext cx="0" cy="380245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직선 연결선 6">
            <a:extLst>
              <a:ext uri="{FF2B5EF4-FFF2-40B4-BE49-F238E27FC236}">
                <a16:creationId xmlns:a16="http://schemas.microsoft.com/office/drawing/2014/main" id="{D23ED057-DB24-4A1C-BC43-42E55D8FDE9D}"/>
              </a:ext>
            </a:extLst>
          </p:cNvPr>
          <p:cNvCxnSpPr/>
          <p:nvPr/>
        </p:nvCxnSpPr>
        <p:spPr>
          <a:xfrm>
            <a:off x="2528283" y="1836334"/>
            <a:ext cx="694800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직선 연결선 7">
            <a:extLst>
              <a:ext uri="{FF2B5EF4-FFF2-40B4-BE49-F238E27FC236}">
                <a16:creationId xmlns:a16="http://schemas.microsoft.com/office/drawing/2014/main" id="{237AED89-DC54-4E1F-B5FB-FBADCC003041}"/>
              </a:ext>
            </a:extLst>
          </p:cNvPr>
          <p:cNvCxnSpPr/>
          <p:nvPr/>
        </p:nvCxnSpPr>
        <p:spPr>
          <a:xfrm>
            <a:off x="9472381" y="1656782"/>
            <a:ext cx="0" cy="380245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>
            <a:extLst>
              <a:ext uri="{FF2B5EF4-FFF2-40B4-BE49-F238E27FC236}">
                <a16:creationId xmlns:a16="http://schemas.microsoft.com/office/drawing/2014/main" id="{21FC5CBF-F74A-4A71-AB49-86D937ADA7A3}"/>
              </a:ext>
            </a:extLst>
          </p:cNvPr>
          <p:cNvSpPr txBox="1"/>
          <p:nvPr/>
        </p:nvSpPr>
        <p:spPr>
          <a:xfrm>
            <a:off x="4477671" y="1367074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d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51A019EA-E737-45F1-A07E-0CFDEE280CE8}"/>
              </a:ext>
            </a:extLst>
          </p:cNvPr>
          <p:cNvSpPr txBox="1"/>
          <p:nvPr/>
        </p:nvSpPr>
        <p:spPr>
          <a:xfrm>
            <a:off x="6696140" y="1374419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d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E65D65CB-2439-4B5E-B7AD-422EF84B5B16}"/>
              </a:ext>
            </a:extLst>
          </p:cNvPr>
          <p:cNvSpPr txBox="1"/>
          <p:nvPr/>
        </p:nvSpPr>
        <p:spPr>
          <a:xfrm>
            <a:off x="8483375" y="1369465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d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C5552076-607D-41BA-AC2A-D551BB4BDC01}"/>
              </a:ext>
            </a:extLst>
          </p:cNvPr>
          <p:cNvSpPr txBox="1"/>
          <p:nvPr/>
        </p:nvSpPr>
        <p:spPr>
          <a:xfrm>
            <a:off x="9277075" y="1357152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d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3" name="직선 화살표 연결선 12">
            <a:extLst>
              <a:ext uri="{FF2B5EF4-FFF2-40B4-BE49-F238E27FC236}">
                <a16:creationId xmlns:a16="http://schemas.microsoft.com/office/drawing/2014/main" id="{29BBAB50-39F7-4BF2-981D-59F0000F44AE}"/>
              </a:ext>
            </a:extLst>
          </p:cNvPr>
          <p:cNvCxnSpPr/>
          <p:nvPr/>
        </p:nvCxnSpPr>
        <p:spPr>
          <a:xfrm>
            <a:off x="2517665" y="2155797"/>
            <a:ext cx="0" cy="235390"/>
          </a:xfrm>
          <a:prstGeom prst="straightConnector1">
            <a:avLst/>
          </a:prstGeom>
          <a:ln w="28575">
            <a:solidFill>
              <a:schemeClr val="tx1"/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직선 화살표 연결선 13">
            <a:extLst>
              <a:ext uri="{FF2B5EF4-FFF2-40B4-BE49-F238E27FC236}">
                <a16:creationId xmlns:a16="http://schemas.microsoft.com/office/drawing/2014/main" id="{281E87A3-FDBD-4CDB-B9B6-7B99EA142348}"/>
              </a:ext>
            </a:extLst>
          </p:cNvPr>
          <p:cNvCxnSpPr/>
          <p:nvPr/>
        </p:nvCxnSpPr>
        <p:spPr>
          <a:xfrm>
            <a:off x="4656458" y="2160560"/>
            <a:ext cx="0" cy="235390"/>
          </a:xfrm>
          <a:prstGeom prst="straightConnector1">
            <a:avLst/>
          </a:prstGeom>
          <a:ln w="28575">
            <a:solidFill>
              <a:schemeClr val="tx1"/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직선 화살표 연결선 14">
            <a:extLst>
              <a:ext uri="{FF2B5EF4-FFF2-40B4-BE49-F238E27FC236}">
                <a16:creationId xmlns:a16="http://schemas.microsoft.com/office/drawing/2014/main" id="{E7FB04E3-DEA5-4A8B-90C4-6BAEA9427E3E}"/>
              </a:ext>
            </a:extLst>
          </p:cNvPr>
          <p:cNvCxnSpPr/>
          <p:nvPr/>
        </p:nvCxnSpPr>
        <p:spPr>
          <a:xfrm>
            <a:off x="6879365" y="2165342"/>
            <a:ext cx="0" cy="235390"/>
          </a:xfrm>
          <a:prstGeom prst="straightConnector1">
            <a:avLst/>
          </a:prstGeom>
          <a:ln w="28575">
            <a:solidFill>
              <a:schemeClr val="tx1"/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직선 화살표 연결선 15">
            <a:extLst>
              <a:ext uri="{FF2B5EF4-FFF2-40B4-BE49-F238E27FC236}">
                <a16:creationId xmlns:a16="http://schemas.microsoft.com/office/drawing/2014/main" id="{DB483856-9EB4-487E-AF8B-DD18D52F5FD3}"/>
              </a:ext>
            </a:extLst>
          </p:cNvPr>
          <p:cNvCxnSpPr/>
          <p:nvPr/>
        </p:nvCxnSpPr>
        <p:spPr>
          <a:xfrm>
            <a:off x="9473234" y="2115494"/>
            <a:ext cx="0" cy="235390"/>
          </a:xfrm>
          <a:prstGeom prst="straightConnector1">
            <a:avLst/>
          </a:prstGeom>
          <a:ln w="28575">
            <a:solidFill>
              <a:schemeClr val="tx1"/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>
            <a:extLst>
              <a:ext uri="{FF2B5EF4-FFF2-40B4-BE49-F238E27FC236}">
                <a16:creationId xmlns:a16="http://schemas.microsoft.com/office/drawing/2014/main" id="{1BD15569-DB94-46F7-A675-D5629992DDA8}"/>
              </a:ext>
            </a:extLst>
          </p:cNvPr>
          <p:cNvSpPr txBox="1"/>
          <p:nvPr/>
        </p:nvSpPr>
        <p:spPr>
          <a:xfrm>
            <a:off x="2173279" y="2446539"/>
            <a:ext cx="6190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M</a:t>
            </a:r>
            <a:r>
              <a:rPr lang="en-US" altLang="ko-KR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012D0954-8AE1-426C-9BD5-5C73E4F50EEB}"/>
              </a:ext>
            </a:extLst>
          </p:cNvPr>
          <p:cNvSpPr txBox="1"/>
          <p:nvPr/>
        </p:nvSpPr>
        <p:spPr>
          <a:xfrm>
            <a:off x="4312077" y="2453665"/>
            <a:ext cx="6190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M</a:t>
            </a:r>
            <a:r>
              <a:rPr lang="en-US" altLang="ko-KR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C86EECDD-26EB-4EA2-95DD-E7BD3FBFCFC8}"/>
              </a:ext>
            </a:extLst>
          </p:cNvPr>
          <p:cNvSpPr txBox="1"/>
          <p:nvPr/>
        </p:nvSpPr>
        <p:spPr>
          <a:xfrm>
            <a:off x="6515650" y="2398947"/>
            <a:ext cx="6190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M</a:t>
            </a:r>
            <a:r>
              <a:rPr lang="en-US" altLang="ko-KR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9D954AC6-005D-4246-955A-083D4F3BBA2E}"/>
              </a:ext>
            </a:extLst>
          </p:cNvPr>
          <p:cNvSpPr txBox="1"/>
          <p:nvPr/>
        </p:nvSpPr>
        <p:spPr>
          <a:xfrm>
            <a:off x="9229285" y="2442815"/>
            <a:ext cx="73449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acrifice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1" name="직선 연결선 20">
            <a:extLst>
              <a:ext uri="{FF2B5EF4-FFF2-40B4-BE49-F238E27FC236}">
                <a16:creationId xmlns:a16="http://schemas.microsoft.com/office/drawing/2014/main" id="{76410753-852E-4A02-9E83-99678670DFB1}"/>
              </a:ext>
            </a:extLst>
          </p:cNvPr>
          <p:cNvCxnSpPr/>
          <p:nvPr/>
        </p:nvCxnSpPr>
        <p:spPr>
          <a:xfrm>
            <a:off x="2527715" y="1663898"/>
            <a:ext cx="0" cy="380245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Box 21">
            <a:extLst>
              <a:ext uri="{FF2B5EF4-FFF2-40B4-BE49-F238E27FC236}">
                <a16:creationId xmlns:a16="http://schemas.microsoft.com/office/drawing/2014/main" id="{7863678C-1350-48F7-A084-5FA79FD39212}"/>
              </a:ext>
            </a:extLst>
          </p:cNvPr>
          <p:cNvSpPr txBox="1"/>
          <p:nvPr/>
        </p:nvSpPr>
        <p:spPr>
          <a:xfrm>
            <a:off x="2338884" y="1391016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d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8483CB87-9A9B-4DE8-BC4B-2BE7E8175143}"/>
              </a:ext>
            </a:extLst>
          </p:cNvPr>
          <p:cNvSpPr txBox="1"/>
          <p:nvPr/>
        </p:nvSpPr>
        <p:spPr>
          <a:xfrm>
            <a:off x="2013229" y="3054261"/>
            <a:ext cx="9589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ko-KR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rouping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6C3B7D7C-40D4-440F-B7B1-70EE44C79A37}"/>
              </a:ext>
            </a:extLst>
          </p:cNvPr>
          <p:cNvSpPr txBox="1"/>
          <p:nvPr/>
        </p:nvSpPr>
        <p:spPr>
          <a:xfrm>
            <a:off x="1807886" y="3289903"/>
            <a:ext cx="1882247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roup1: </a:t>
            </a:r>
            <a:r>
              <a:rPr lang="en-US" altLang="ko-KR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alb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en-US" altLang="ko-KR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_Normal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NC)</a:t>
            </a:r>
          </a:p>
          <a:p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roup2: PM</a:t>
            </a:r>
            <a:r>
              <a:rPr lang="en-US" altLang="ko-KR" sz="1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</a:p>
        </p:txBody>
      </p:sp>
      <p:cxnSp>
        <p:nvCxnSpPr>
          <p:cNvPr id="28" name="직선 화살표 연결선 27">
            <a:extLst>
              <a:ext uri="{FF2B5EF4-FFF2-40B4-BE49-F238E27FC236}">
                <a16:creationId xmlns:a16="http://schemas.microsoft.com/office/drawing/2014/main" id="{01513CE2-9092-4FDC-821F-BE97820DC5EC}"/>
              </a:ext>
            </a:extLst>
          </p:cNvPr>
          <p:cNvCxnSpPr>
            <a:cxnSpLocks/>
          </p:cNvCxnSpPr>
          <p:nvPr/>
        </p:nvCxnSpPr>
        <p:spPr>
          <a:xfrm>
            <a:off x="2525043" y="2731435"/>
            <a:ext cx="0" cy="235390"/>
          </a:xfrm>
          <a:prstGeom prst="straightConnector1">
            <a:avLst/>
          </a:prstGeom>
          <a:ln w="28575">
            <a:solidFill>
              <a:schemeClr val="tx1"/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직선 연결선 28">
            <a:extLst>
              <a:ext uri="{FF2B5EF4-FFF2-40B4-BE49-F238E27FC236}">
                <a16:creationId xmlns:a16="http://schemas.microsoft.com/office/drawing/2014/main" id="{AB2E64A3-7842-4F46-BE14-1B2AD643089F}"/>
              </a:ext>
            </a:extLst>
          </p:cNvPr>
          <p:cNvCxnSpPr/>
          <p:nvPr/>
        </p:nvCxnSpPr>
        <p:spPr>
          <a:xfrm>
            <a:off x="6874194" y="1648156"/>
            <a:ext cx="0" cy="380245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직선 연결선 29">
            <a:extLst>
              <a:ext uri="{FF2B5EF4-FFF2-40B4-BE49-F238E27FC236}">
                <a16:creationId xmlns:a16="http://schemas.microsoft.com/office/drawing/2014/main" id="{E06D4BA7-B36E-42E8-8D4D-1321EF926542}"/>
              </a:ext>
            </a:extLst>
          </p:cNvPr>
          <p:cNvCxnSpPr/>
          <p:nvPr/>
        </p:nvCxnSpPr>
        <p:spPr>
          <a:xfrm>
            <a:off x="8673978" y="1651418"/>
            <a:ext cx="0" cy="380245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직선 화살표 연결선 31">
            <a:extLst>
              <a:ext uri="{FF2B5EF4-FFF2-40B4-BE49-F238E27FC236}">
                <a16:creationId xmlns:a16="http://schemas.microsoft.com/office/drawing/2014/main" id="{0737C41B-E98A-4D4A-96F2-19388706A477}"/>
              </a:ext>
            </a:extLst>
          </p:cNvPr>
          <p:cNvCxnSpPr>
            <a:cxnSpLocks/>
          </p:cNvCxnSpPr>
          <p:nvPr/>
        </p:nvCxnSpPr>
        <p:spPr>
          <a:xfrm>
            <a:off x="4656458" y="2751652"/>
            <a:ext cx="0" cy="235390"/>
          </a:xfrm>
          <a:prstGeom prst="straightConnector1">
            <a:avLst/>
          </a:prstGeom>
          <a:ln w="28575">
            <a:solidFill>
              <a:schemeClr val="tx1"/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TextBox 32">
            <a:extLst>
              <a:ext uri="{FF2B5EF4-FFF2-40B4-BE49-F238E27FC236}">
                <a16:creationId xmlns:a16="http://schemas.microsoft.com/office/drawing/2014/main" id="{24359E47-42B0-4E9A-B05B-3BED355D13F3}"/>
              </a:ext>
            </a:extLst>
          </p:cNvPr>
          <p:cNvSpPr txBox="1"/>
          <p:nvPr/>
        </p:nvSpPr>
        <p:spPr>
          <a:xfrm>
            <a:off x="4154983" y="3291838"/>
            <a:ext cx="4802918" cy="110799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roup 1: </a:t>
            </a:r>
            <a:r>
              <a:rPr lang="en-US" altLang="ko-KR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alb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en-US" altLang="ko-KR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_Normal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+ Vehicle (NC)</a:t>
            </a:r>
          </a:p>
          <a:p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roup 2: PM</a:t>
            </a:r>
            <a:r>
              <a:rPr lang="en-US" altLang="ko-KR" sz="1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 + Vehicle (CTL)</a:t>
            </a:r>
          </a:p>
          <a:p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roup 3: PM</a:t>
            </a:r>
            <a:r>
              <a:rPr lang="en-US" altLang="ko-KR" sz="1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 + </a:t>
            </a:r>
            <a:r>
              <a:rPr lang="en-US" altLang="ko-KR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xa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3 mg/kg(</a:t>
            </a:r>
            <a:r>
              <a:rPr lang="en-US" altLang="ko-KR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xa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  <a:p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roup 4: PM</a:t>
            </a:r>
            <a:r>
              <a:rPr lang="en-US" altLang="ko-KR" sz="1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 + Heat-killed </a:t>
            </a:r>
            <a:r>
              <a:rPr lang="en-US" altLang="ko-KR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. </a:t>
            </a:r>
            <a:r>
              <a:rPr lang="en-US" altLang="ko-KR" sz="11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aracasei</a:t>
            </a:r>
            <a:r>
              <a:rPr lang="en-US" altLang="ko-KR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G-E1 1X10</a:t>
            </a:r>
            <a:r>
              <a:rPr lang="en-US" altLang="ko-KR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otal cell No. (H)</a:t>
            </a:r>
          </a:p>
          <a:p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roup 5: PM</a:t>
            </a:r>
            <a:r>
              <a:rPr lang="en-US" altLang="ko-KR" sz="1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 + Heat-killed</a:t>
            </a:r>
            <a:r>
              <a:rPr lang="en-US" altLang="ko-KR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. </a:t>
            </a:r>
            <a:r>
              <a:rPr lang="en-US" altLang="ko-KR" sz="11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aracasei</a:t>
            </a:r>
            <a:r>
              <a:rPr lang="en-US" altLang="ko-KR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G-E1 1X10</a:t>
            </a:r>
            <a:r>
              <a:rPr lang="en-US" altLang="ko-KR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 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tal cell No. (M)</a:t>
            </a:r>
          </a:p>
          <a:p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roup 6: PM</a:t>
            </a:r>
            <a:r>
              <a:rPr lang="en-US" altLang="ko-KR" sz="1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 +</a:t>
            </a:r>
            <a:r>
              <a:rPr lang="en-US" altLang="ko-KR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eat-killed </a:t>
            </a:r>
            <a:r>
              <a:rPr lang="en-US" altLang="ko-KR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. </a:t>
            </a:r>
            <a:r>
              <a:rPr lang="en-US" altLang="ko-KR" sz="11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aracasei</a:t>
            </a:r>
            <a:r>
              <a:rPr lang="en-US" altLang="ko-KR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G-E1 1X10</a:t>
            </a:r>
            <a:r>
              <a:rPr lang="en-US" altLang="ko-KR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otal cell No.(L)</a:t>
            </a:r>
          </a:p>
        </p:txBody>
      </p:sp>
      <p:sp>
        <p:nvSpPr>
          <p:cNvPr id="37" name="화살표: 오른쪽 36">
            <a:extLst>
              <a:ext uri="{FF2B5EF4-FFF2-40B4-BE49-F238E27FC236}">
                <a16:creationId xmlns:a16="http://schemas.microsoft.com/office/drawing/2014/main" id="{8694161B-3097-4E4F-AAA6-874E895E3EAE}"/>
              </a:ext>
            </a:extLst>
          </p:cNvPr>
          <p:cNvSpPr/>
          <p:nvPr/>
        </p:nvSpPr>
        <p:spPr>
          <a:xfrm>
            <a:off x="4683008" y="1015195"/>
            <a:ext cx="3870799" cy="357563"/>
          </a:xfrm>
          <a:prstGeom prst="rightArrow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D947487D-528C-4AB1-AC2F-5D456528B67A}"/>
              </a:ext>
            </a:extLst>
          </p:cNvPr>
          <p:cNvSpPr txBox="1"/>
          <p:nvPr/>
        </p:nvSpPr>
        <p:spPr>
          <a:xfrm>
            <a:off x="5271371" y="1060705"/>
            <a:ext cx="24454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. </a:t>
            </a:r>
            <a:r>
              <a:rPr lang="en-US" altLang="ko-KR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aracasei</a:t>
            </a:r>
            <a:r>
              <a:rPr lang="en-US" altLang="ko-KR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G-E1 administration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54D0A300-08AE-427D-8CBC-3824102474E7}"/>
              </a:ext>
            </a:extLst>
          </p:cNvPr>
          <p:cNvSpPr txBox="1"/>
          <p:nvPr/>
        </p:nvSpPr>
        <p:spPr>
          <a:xfrm>
            <a:off x="4154983" y="3032091"/>
            <a:ext cx="9925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ko-KR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d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rouping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C7519C90-20CB-4958-811B-EB1687685B0F}"/>
              </a:ext>
            </a:extLst>
          </p:cNvPr>
          <p:cNvSpPr txBox="1"/>
          <p:nvPr/>
        </p:nvSpPr>
        <p:spPr>
          <a:xfrm>
            <a:off x="2525043" y="5541193"/>
            <a:ext cx="32111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 Figure S7. Experimental scheme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602285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Yu Gothic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Yu Gothic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651</TotalTime>
  <Words>1124</Words>
  <Application>Microsoft Office PowerPoint</Application>
  <PresentationFormat>와이드스크린</PresentationFormat>
  <Paragraphs>103</Paragraphs>
  <Slides>10</Slides>
  <Notes>0</Notes>
  <HiddenSlides>0</HiddenSlides>
  <MMClips>0</MMClips>
  <ScaleCrop>false</ScaleCrop>
  <HeadingPairs>
    <vt:vector size="8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포함된 OLE 서버</vt:lpstr>
      </vt:variant>
      <vt:variant>
        <vt:i4>1</vt:i4>
      </vt:variant>
      <vt:variant>
        <vt:lpstr>슬라이드 제목</vt:lpstr>
      </vt:variant>
      <vt:variant>
        <vt:i4>10</vt:i4>
      </vt:variant>
    </vt:vector>
  </HeadingPairs>
  <TitlesOfParts>
    <vt:vector size="15" baseType="lpstr">
      <vt:lpstr>Arial</vt:lpstr>
      <vt:lpstr>Times New Roman</vt:lpstr>
      <vt:lpstr>맑은 고딕</vt:lpstr>
      <vt:lpstr>Office 테마</vt:lpstr>
      <vt:lpstr>Prism 8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ATOGEN company</dc:creator>
  <cp:lastModifiedBy>Young-Sil</cp:lastModifiedBy>
  <cp:revision>73</cp:revision>
  <dcterms:created xsi:type="dcterms:W3CDTF">2023-09-07T07:23:52Z</dcterms:created>
  <dcterms:modified xsi:type="dcterms:W3CDTF">2026-06-30T05:18:01Z</dcterms:modified>
  <cp:version/>
</cp:coreProperties>
</file>